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eorgia" initials="G" lastIdx="7" clrIdx="0"/>
  <p:cmAuthor id="1" name="dimitris" initials="d" lastIdx="3" clrIdx="1"/>
  <p:cmAuthor id="2" name="Georgia" initials="Geo" lastIdx="14" clrIdx="2"/>
  <p:cmAuthor id="3" name="Argie" initials="AAV" lastIdx="4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78034"/>
    <a:srgbClr val="7A983E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149" autoAdjust="0"/>
    <p:restoredTop sz="99200" autoAdjust="0"/>
  </p:normalViewPr>
  <p:slideViewPr>
    <p:cSldViewPr>
      <p:cViewPr>
        <p:scale>
          <a:sx n="70" d="100"/>
          <a:sy n="70" d="100"/>
        </p:scale>
        <p:origin x="-1860" y="-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EC22BB-136E-479C-8E85-3E7123323982}" type="datetimeFigureOut">
              <a:rPr lang="en-GB" smtClean="0"/>
              <a:t>08/06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0B5BC7-ED4F-4DDB-B1BF-58A2454210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97717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5" name="Group 174"/>
          <p:cNvGrpSpPr/>
          <p:nvPr/>
        </p:nvGrpSpPr>
        <p:grpSpPr>
          <a:xfrm>
            <a:off x="243989" y="76200"/>
            <a:ext cx="8671411" cy="6359872"/>
            <a:chOff x="243989" y="76200"/>
            <a:chExt cx="8671411" cy="6359872"/>
          </a:xfrm>
        </p:grpSpPr>
        <p:grpSp>
          <p:nvGrpSpPr>
            <p:cNvPr id="4" name="Group 3"/>
            <p:cNvGrpSpPr/>
            <p:nvPr/>
          </p:nvGrpSpPr>
          <p:grpSpPr>
            <a:xfrm>
              <a:off x="243989" y="76200"/>
              <a:ext cx="8613220" cy="6359872"/>
              <a:chOff x="243989" y="76200"/>
              <a:chExt cx="8613220" cy="6359872"/>
            </a:xfrm>
          </p:grpSpPr>
          <p:sp>
            <p:nvSpPr>
              <p:cNvPr id="5" name="Rectangle 87"/>
              <p:cNvSpPr>
                <a:spLocks noChangeArrowheads="1"/>
              </p:cNvSpPr>
              <p:nvPr/>
            </p:nvSpPr>
            <p:spPr bwMode="auto">
              <a:xfrm rot="16200000">
                <a:off x="-322123" y="3091231"/>
                <a:ext cx="13476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ype I error</a:t>
                </a:r>
                <a:endParaRPr kumimoji="0" lang="el-GR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6" name="Rectangle 5"/>
                  <p:cNvSpPr/>
                  <p:nvPr/>
                </p:nvSpPr>
                <p:spPr>
                  <a:xfrm>
                    <a:off x="1317628" y="398551"/>
                    <a:ext cx="2522037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GB" sz="1400" i="1" dirty="0" smtClean="0"/>
                      <a:t>a. </a:t>
                    </a:r>
                    <a:r>
                      <a:rPr lang="en-US" sz="1400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frequent events with </a:t>
                    </a:r>
                    <a14:m>
                      <m:oMath xmlns:m="http://schemas.openxmlformats.org/officeDocument/2006/math">
                        <m:sSup>
                          <m:sSupPr>
                            <m:ctrlPr>
                              <a:rPr lang="el-GR" sz="1400" b="0" i="1" smtClean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</m:ctrlPr>
                          </m:sSupPr>
                          <m:e>
                            <m:r>
                              <a:rPr lang="el-GR" sz="1400" b="0" i="1" smtClean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𝜏</m:t>
                            </m:r>
                          </m:e>
                          <m:sup>
                            <m:r>
                              <a:rPr lang="el-GR" sz="1400" b="0" i="1" smtClean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2</m:t>
                            </m:r>
                          </m:sup>
                        </m:sSup>
                        <m:r>
                          <a:rPr lang="el-GR" sz="1400" b="0" i="1" smtClean="0">
                            <a:solidFill>
                              <a:srgbClr val="000000"/>
                            </a:solidFill>
                            <a:latin typeface="Cambria Math"/>
                            <a:ea typeface="Cambria Math"/>
                            <a:cs typeface="Arial" pitchFamily="34" charset="0"/>
                          </a:rPr>
                          <m:t>≠0</m:t>
                        </m:r>
                      </m:oMath>
                    </a14:m>
                    <a:endParaRPr lang="el-GR" sz="1400" dirty="0"/>
                  </a:p>
                </p:txBody>
              </p:sp>
            </mc:Choice>
            <mc:Fallback xmlns="">
              <p:sp>
                <p:nvSpPr>
                  <p:cNvPr id="1065" name="Rectangle 1064"/>
                  <p:cNvSpPr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1317628" y="398551"/>
                    <a:ext cx="2522037" cy="307777"/>
                  </a:xfrm>
                  <a:prstGeom prst="rect">
                    <a:avLst/>
                  </a:prstGeom>
                  <a:blipFill rotWithShape="1">
                    <a:blip r:embed="rId3"/>
                    <a:stretch>
                      <a:fillRect t="-1961" r="-2174" b="-19608"/>
                    </a:stretch>
                  </a:blipFill>
                </p:spPr>
                <p:txBody>
                  <a:bodyPr/>
                  <a:lstStyle/>
                  <a:p>
                    <a:r>
                      <a:rPr lang="el-GR">
                        <a:noFill/>
                      </a:rPr>
                      <a:t> </a:t>
                    </a:r>
                  </a:p>
                </p:txBody>
              </p:sp>
            </mc:Fallback>
          </mc:AlternateContent>
          <p:sp>
            <p:nvSpPr>
              <p:cNvPr id="7" name="Rectangle 86"/>
              <p:cNvSpPr>
                <a:spLocks noChangeArrowheads="1"/>
              </p:cNvSpPr>
              <p:nvPr/>
            </p:nvSpPr>
            <p:spPr bwMode="auto">
              <a:xfrm>
                <a:off x="1890765" y="6220628"/>
                <a:ext cx="565168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4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Total number of </a:t>
                </a:r>
                <a:r>
                  <a:rPr lang="en-US" sz="14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individuals in the loop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8" name="Rectangle 7"/>
                  <p:cNvSpPr/>
                  <p:nvPr/>
                </p:nvSpPr>
                <p:spPr>
                  <a:xfrm>
                    <a:off x="5568543" y="398551"/>
                    <a:ext cx="2522037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GB" sz="1400" i="1" dirty="0" smtClean="0"/>
                      <a:t>b. </a:t>
                    </a:r>
                    <a:r>
                      <a:rPr lang="en-US" sz="1400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frequent events</a:t>
                    </a:r>
                    <a:r>
                      <a:rPr lang="el-GR" sz="1400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 </a:t>
                    </a:r>
                    <a:r>
                      <a:rPr lang="en-US" sz="1400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with </a:t>
                    </a:r>
                    <a14:m>
                      <m:oMath xmlns:m="http://schemas.openxmlformats.org/officeDocument/2006/math">
                        <m:sSup>
                          <m:sSupPr>
                            <m:ctrlPr>
                              <a:rPr lang="el-GR" sz="1400" i="1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</m:ctrlPr>
                          </m:sSupPr>
                          <m:e>
                            <m:r>
                              <a:rPr lang="el-GR" sz="1400" i="1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𝜏</m:t>
                            </m:r>
                          </m:e>
                          <m:sup>
                            <m:r>
                              <a:rPr lang="el-GR" sz="1400" i="1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2</m:t>
                            </m:r>
                          </m:sup>
                        </m:sSup>
                        <m:r>
                          <a:rPr lang="en-US" sz="1400" b="0" i="1" smtClean="0">
                            <a:solidFill>
                              <a:srgbClr val="000000"/>
                            </a:solidFill>
                            <a:latin typeface="Cambria Math"/>
                            <a:ea typeface="Cambria Math"/>
                            <a:cs typeface="Arial" pitchFamily="34" charset="0"/>
                          </a:rPr>
                          <m:t>=</m:t>
                        </m:r>
                        <m:r>
                          <a:rPr lang="el-GR" sz="1400" i="1">
                            <a:solidFill>
                              <a:srgbClr val="000000"/>
                            </a:solidFill>
                            <a:latin typeface="Cambria Math"/>
                            <a:ea typeface="Cambria Math"/>
                            <a:cs typeface="Arial" pitchFamily="34" charset="0"/>
                          </a:rPr>
                          <m:t>0</m:t>
                        </m:r>
                      </m:oMath>
                    </a14:m>
                    <a:endParaRPr lang="el-GR" sz="1400" dirty="0"/>
                  </a:p>
                </p:txBody>
              </p:sp>
            </mc:Choice>
            <mc:Fallback xmlns="">
              <p:sp>
                <p:nvSpPr>
                  <p:cNvPr id="1064" name="Rectangle 1063"/>
                  <p:cNvSpPr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5568543" y="398551"/>
                    <a:ext cx="2522037" cy="307777"/>
                  </a:xfrm>
                  <a:prstGeom prst="rect">
                    <a:avLst/>
                  </a:prstGeom>
                  <a:blipFill rotWithShape="1">
                    <a:blip r:embed="rId4"/>
                    <a:stretch>
                      <a:fillRect t="-1961" r="-2174" b="-19608"/>
                    </a:stretch>
                  </a:blipFill>
                </p:spPr>
                <p:txBody>
                  <a:bodyPr/>
                  <a:lstStyle/>
                  <a:p>
                    <a:r>
                      <a:rPr lang="el-GR">
                        <a:noFill/>
                      </a:rPr>
                      <a:t> </a:t>
                    </a:r>
                  </a:p>
                </p:txBody>
              </p:sp>
            </mc:Fallback>
          </mc:AlternateContent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9" name="Rectangle 8"/>
                  <p:cNvSpPr/>
                  <p:nvPr/>
                </p:nvSpPr>
                <p:spPr>
                  <a:xfrm>
                    <a:off x="1471147" y="3276600"/>
                    <a:ext cx="2457019" cy="338554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GB" sz="1600" i="1" dirty="0" smtClean="0"/>
                      <a:t>c. </a:t>
                    </a:r>
                    <a:r>
                      <a:rPr lang="en-US" sz="1600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rare events </a:t>
                    </a:r>
                    <a:r>
                      <a:rPr lang="en-US" sz="1600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with </a:t>
                    </a:r>
                    <a14:m>
                      <m:oMath xmlns:m="http://schemas.openxmlformats.org/officeDocument/2006/math">
                        <m:sSup>
                          <m:sSupPr>
                            <m:ctrlPr>
                              <a:rPr lang="el-GR" sz="1600" b="0" i="1" smtClean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</m:ctrlPr>
                          </m:sSupPr>
                          <m:e>
                            <m:r>
                              <a:rPr lang="el-GR" sz="1600" b="0" i="1" smtClean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𝜏</m:t>
                            </m:r>
                          </m:e>
                          <m:sup>
                            <m:r>
                              <a:rPr lang="el-GR" sz="1600" b="0" i="1" smtClean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2</m:t>
                            </m:r>
                          </m:sup>
                        </m:sSup>
                        <m:r>
                          <a:rPr lang="el-GR" sz="1600" b="0" i="1" smtClean="0">
                            <a:solidFill>
                              <a:srgbClr val="000000"/>
                            </a:solidFill>
                            <a:latin typeface="Cambria Math"/>
                            <a:ea typeface="Cambria Math"/>
                            <a:cs typeface="Arial" pitchFamily="34" charset="0"/>
                          </a:rPr>
                          <m:t>≠0</m:t>
                        </m:r>
                      </m:oMath>
                    </a14:m>
                    <a:endParaRPr lang="el-GR" sz="1600" dirty="0"/>
                  </a:p>
                </p:txBody>
              </p:sp>
            </mc:Choice>
            <mc:Fallback xmlns="">
              <p:sp>
                <p:nvSpPr>
                  <p:cNvPr id="1015" name="Rectangle 1014"/>
                  <p:cNvSpPr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1471147" y="3276600"/>
                    <a:ext cx="2457019" cy="338554"/>
                  </a:xfrm>
                  <a:prstGeom prst="rect">
                    <a:avLst/>
                  </a:prstGeom>
                  <a:blipFill rotWithShape="1">
                    <a:blip r:embed="rId5"/>
                    <a:stretch>
                      <a:fillRect l="-744" t="-7273" r="-2730" b="-21818"/>
                    </a:stretch>
                  </a:blipFill>
                </p:spPr>
                <p:txBody>
                  <a:bodyPr/>
                  <a:lstStyle/>
                  <a:p>
                    <a:r>
                      <a:rPr lang="el-GR">
                        <a:noFill/>
                      </a:rPr>
                      <a:t> </a:t>
                    </a:r>
                  </a:p>
                </p:txBody>
              </p:sp>
            </mc:Fallback>
          </mc:AlternateContent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10" name="Rectangle 9"/>
                  <p:cNvSpPr/>
                  <p:nvPr/>
                </p:nvSpPr>
                <p:spPr>
                  <a:xfrm>
                    <a:off x="5628584" y="3276600"/>
                    <a:ext cx="2477858" cy="338554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GB" sz="1600" i="1" dirty="0" smtClean="0"/>
                      <a:t>d. </a:t>
                    </a:r>
                    <a:r>
                      <a:rPr lang="en-US" sz="1600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rare events </a:t>
                    </a:r>
                    <a:r>
                      <a:rPr lang="en-US" sz="1600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with </a:t>
                    </a:r>
                    <a14:m>
                      <m:oMath xmlns:m="http://schemas.openxmlformats.org/officeDocument/2006/math">
                        <m:sSup>
                          <m:sSupPr>
                            <m:ctrlPr>
                              <a:rPr lang="el-GR" sz="1600" b="0" i="1" smtClean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</m:ctrlPr>
                          </m:sSupPr>
                          <m:e>
                            <m:r>
                              <a:rPr lang="el-GR" sz="1600" b="0" i="1" smtClean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𝜏</m:t>
                            </m:r>
                          </m:e>
                          <m:sup>
                            <m:r>
                              <a:rPr lang="el-GR" sz="1600" b="0" i="1" smtClean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2</m:t>
                            </m:r>
                          </m:sup>
                        </m:sSup>
                        <m:r>
                          <a:rPr lang="en-US" sz="1600" b="0" i="1" smtClean="0">
                            <a:solidFill>
                              <a:srgbClr val="000000"/>
                            </a:solidFill>
                            <a:latin typeface="Cambria Math"/>
                            <a:ea typeface="Cambria Math"/>
                            <a:cs typeface="Arial" pitchFamily="34" charset="0"/>
                          </a:rPr>
                          <m:t>=</m:t>
                        </m:r>
                        <m:r>
                          <a:rPr lang="el-GR" sz="1600" b="0" i="1" smtClean="0">
                            <a:solidFill>
                              <a:srgbClr val="000000"/>
                            </a:solidFill>
                            <a:latin typeface="Cambria Math"/>
                            <a:ea typeface="Cambria Math"/>
                            <a:cs typeface="Arial" pitchFamily="34" charset="0"/>
                          </a:rPr>
                          <m:t>0</m:t>
                        </m:r>
                      </m:oMath>
                    </a14:m>
                    <a:endParaRPr lang="el-GR" sz="1600" dirty="0"/>
                  </a:p>
                </p:txBody>
              </p:sp>
            </mc:Choice>
            <mc:Fallback xmlns="">
              <p:sp>
                <p:nvSpPr>
                  <p:cNvPr id="1162" name="Rectangle 1161"/>
                  <p:cNvSpPr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5628584" y="3276600"/>
                    <a:ext cx="2477858" cy="338554"/>
                  </a:xfrm>
                  <a:prstGeom prst="rect">
                    <a:avLst/>
                  </a:prstGeom>
                  <a:blipFill rotWithShape="1">
                    <a:blip r:embed="rId6"/>
                    <a:stretch>
                      <a:fillRect l="-983" t="-7273" r="-2457" b="-21818"/>
                    </a:stretch>
                  </a:blipFill>
                </p:spPr>
                <p:txBody>
                  <a:bodyPr/>
                  <a:lstStyle/>
                  <a:p>
                    <a:r>
                      <a:rPr lang="el-GR">
                        <a:noFill/>
                      </a:rPr>
                      <a:t> </a:t>
                    </a:r>
                  </a:p>
                </p:txBody>
              </p:sp>
            </mc:Fallback>
          </mc:AlternateContent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12" name="Rectangle 301"/>
                  <p:cNvSpPr>
                    <a:spLocks noChangeArrowheads="1"/>
                  </p:cNvSpPr>
                  <p:nvPr/>
                </p:nvSpPr>
                <p:spPr bwMode="auto">
                  <a:xfrm>
                    <a:off x="2447302" y="76200"/>
                    <a:ext cx="4079643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lvl="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400" b="1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Imbalanced Scenario (</a:t>
                    </a:r>
                    <a14:m>
                      <m:oMath xmlns:m="http://schemas.openxmlformats.org/officeDocument/2006/math">
                        <m:sSub>
                          <m:sSubPr>
                            <m:ctrlP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</m:ctrlPr>
                          </m:sSubPr>
                          <m:e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𝑲</m:t>
                            </m:r>
                          </m:e>
                          <m:sub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𝑨𝑩</m:t>
                            </m:r>
                          </m:sub>
                        </m:sSub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=</m:t>
                        </m:r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𝟏</m:t>
                        </m:r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,</m:t>
                        </m:r>
                        <m:sSub>
                          <m:sSubPr>
                            <m:ctrlP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</m:ctrlPr>
                          </m:sSubPr>
                          <m:e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𝑲</m:t>
                            </m:r>
                          </m:e>
                          <m:sub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𝑨𝑪</m:t>
                            </m:r>
                          </m:sub>
                        </m:sSub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=</m:t>
                        </m:r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𝟒</m:t>
                        </m:r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,</m:t>
                        </m:r>
                        <m:sSub>
                          <m:sSubPr>
                            <m:ctrlP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</m:ctrlPr>
                          </m:sSubPr>
                          <m:e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𝑲</m:t>
                            </m:r>
                          </m:e>
                          <m:sub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𝑩𝑪</m:t>
                            </m:r>
                          </m:sub>
                        </m:sSub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=</m:t>
                        </m:r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𝟕</m:t>
                        </m:r>
                      </m:oMath>
                    </a14:m>
                    <a:r>
                      <a:rPr lang="en-US" sz="1400" b="1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)</a:t>
                    </a:r>
                    <a:endParaRPr lang="el-GR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mc:Choice>
            <mc:Fallback xmlns="">
              <p:sp>
                <p:nvSpPr>
                  <p:cNvPr id="476" name="Rectangle 301"/>
                  <p:cNvSpPr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 bwMode="auto">
                  <a:xfrm>
                    <a:off x="2447302" y="76200"/>
                    <a:ext cx="4079643" cy="215444"/>
                  </a:xfrm>
                  <a:prstGeom prst="rect">
                    <a:avLst/>
                  </a:prstGeom>
                  <a:blipFill rotWithShape="1">
                    <a:blip r:embed="rId10"/>
                    <a:stretch>
                      <a:fillRect l="-2537" t="-25714" r="-3134" b="-48571"/>
                    </a:stretch>
                  </a:blipFill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r>
                      <a:rPr lang="el-GR">
                        <a:noFill/>
                      </a:rPr>
                      <a:t> </a:t>
                    </a:r>
                  </a:p>
                </p:txBody>
              </p:sp>
            </mc:Fallback>
          </mc:AlternateContent>
          <p:grpSp>
            <p:nvGrpSpPr>
              <p:cNvPr id="13" name="Group 12"/>
              <p:cNvGrpSpPr/>
              <p:nvPr/>
            </p:nvGrpSpPr>
            <p:grpSpPr>
              <a:xfrm>
                <a:off x="609600" y="771030"/>
                <a:ext cx="3808670" cy="2429370"/>
                <a:chOff x="449005" y="485538"/>
                <a:chExt cx="3808670" cy="2521703"/>
              </a:xfrm>
            </p:grpSpPr>
            <p:sp>
              <p:nvSpPr>
                <p:cNvPr id="117" name="Freeform 6"/>
                <p:cNvSpPr>
                  <a:spLocks/>
                </p:cNvSpPr>
                <p:nvPr/>
              </p:nvSpPr>
              <p:spPr bwMode="auto">
                <a:xfrm>
                  <a:off x="838200" y="2203450"/>
                  <a:ext cx="76200" cy="66675"/>
                </a:xfrm>
                <a:custGeom>
                  <a:avLst/>
                  <a:gdLst>
                    <a:gd name="T0" fmla="*/ 24 w 48"/>
                    <a:gd name="T1" fmla="*/ 0 h 42"/>
                    <a:gd name="T2" fmla="*/ 48 w 48"/>
                    <a:gd name="T3" fmla="*/ 42 h 42"/>
                    <a:gd name="T4" fmla="*/ 0 w 48"/>
                    <a:gd name="T5" fmla="*/ 42 h 42"/>
                    <a:gd name="T6" fmla="*/ 24 w 48"/>
                    <a:gd name="T7" fmla="*/ 0 h 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8" h="42">
                      <a:moveTo>
                        <a:pt x="24" y="0"/>
                      </a:moveTo>
                      <a:lnTo>
                        <a:pt x="48" y="42"/>
                      </a:lnTo>
                      <a:lnTo>
                        <a:pt x="0" y="42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18" name="Freeform 7"/>
                <p:cNvSpPr>
                  <a:spLocks/>
                </p:cNvSpPr>
                <p:nvPr/>
              </p:nvSpPr>
              <p:spPr bwMode="auto">
                <a:xfrm>
                  <a:off x="2676525" y="2022475"/>
                  <a:ext cx="76200" cy="66675"/>
                </a:xfrm>
                <a:custGeom>
                  <a:avLst/>
                  <a:gdLst>
                    <a:gd name="T0" fmla="*/ 24 w 48"/>
                    <a:gd name="T1" fmla="*/ 0 h 42"/>
                    <a:gd name="T2" fmla="*/ 48 w 48"/>
                    <a:gd name="T3" fmla="*/ 42 h 42"/>
                    <a:gd name="T4" fmla="*/ 0 w 48"/>
                    <a:gd name="T5" fmla="*/ 42 h 42"/>
                    <a:gd name="T6" fmla="*/ 24 w 48"/>
                    <a:gd name="T7" fmla="*/ 0 h 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8" h="42">
                      <a:moveTo>
                        <a:pt x="24" y="0"/>
                      </a:moveTo>
                      <a:lnTo>
                        <a:pt x="48" y="42"/>
                      </a:lnTo>
                      <a:lnTo>
                        <a:pt x="0" y="42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19" name="Freeform 8"/>
                <p:cNvSpPr>
                  <a:spLocks/>
                </p:cNvSpPr>
                <p:nvPr/>
              </p:nvSpPr>
              <p:spPr bwMode="auto">
                <a:xfrm>
                  <a:off x="4086225" y="2136775"/>
                  <a:ext cx="76200" cy="66675"/>
                </a:xfrm>
                <a:custGeom>
                  <a:avLst/>
                  <a:gdLst>
                    <a:gd name="T0" fmla="*/ 24 w 48"/>
                    <a:gd name="T1" fmla="*/ 0 h 42"/>
                    <a:gd name="T2" fmla="*/ 48 w 48"/>
                    <a:gd name="T3" fmla="*/ 42 h 42"/>
                    <a:gd name="T4" fmla="*/ 0 w 48"/>
                    <a:gd name="T5" fmla="*/ 42 h 42"/>
                    <a:gd name="T6" fmla="*/ 24 w 48"/>
                    <a:gd name="T7" fmla="*/ 0 h 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8" h="42">
                      <a:moveTo>
                        <a:pt x="24" y="0"/>
                      </a:moveTo>
                      <a:lnTo>
                        <a:pt x="48" y="42"/>
                      </a:lnTo>
                      <a:lnTo>
                        <a:pt x="0" y="42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20" name="Line 9"/>
                <p:cNvSpPr>
                  <a:spLocks noChangeShapeType="1"/>
                </p:cNvSpPr>
                <p:nvPr/>
              </p:nvSpPr>
              <p:spPr bwMode="auto">
                <a:xfrm>
                  <a:off x="1181100" y="2660650"/>
                  <a:ext cx="28098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21" name="Line 10"/>
                <p:cNvSpPr>
                  <a:spLocks noChangeShapeType="1"/>
                </p:cNvSpPr>
                <p:nvPr/>
              </p:nvSpPr>
              <p:spPr bwMode="auto">
                <a:xfrm>
                  <a:off x="1181100" y="2660650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22" name="Line 11"/>
                <p:cNvSpPr>
                  <a:spLocks noChangeShapeType="1"/>
                </p:cNvSpPr>
                <p:nvPr/>
              </p:nvSpPr>
              <p:spPr bwMode="auto">
                <a:xfrm>
                  <a:off x="2390775" y="2660650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23" name="Line 12"/>
                <p:cNvSpPr>
                  <a:spLocks noChangeShapeType="1"/>
                </p:cNvSpPr>
                <p:nvPr/>
              </p:nvSpPr>
              <p:spPr bwMode="auto">
                <a:xfrm>
                  <a:off x="3095625" y="2660650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24" name="Line 13"/>
                <p:cNvSpPr>
                  <a:spLocks noChangeShapeType="1"/>
                </p:cNvSpPr>
                <p:nvPr/>
              </p:nvSpPr>
              <p:spPr bwMode="auto">
                <a:xfrm>
                  <a:off x="3600450" y="2660650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25" name="Line 14"/>
                <p:cNvSpPr>
                  <a:spLocks noChangeShapeType="1"/>
                </p:cNvSpPr>
                <p:nvPr/>
              </p:nvSpPr>
              <p:spPr bwMode="auto">
                <a:xfrm>
                  <a:off x="3990975" y="2660650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26" name="Rectangle 15"/>
                <p:cNvSpPr>
                  <a:spLocks noChangeArrowheads="1"/>
                </p:cNvSpPr>
                <p:nvPr/>
              </p:nvSpPr>
              <p:spPr bwMode="auto">
                <a:xfrm>
                  <a:off x="1014413" y="2822575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7" name="Rectangle 16"/>
                <p:cNvSpPr>
                  <a:spLocks noChangeArrowheads="1"/>
                </p:cNvSpPr>
                <p:nvPr/>
              </p:nvSpPr>
              <p:spPr bwMode="auto">
                <a:xfrm>
                  <a:off x="2224088" y="2822575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8" name="Rectangle 17"/>
                <p:cNvSpPr>
                  <a:spLocks noChangeArrowheads="1"/>
                </p:cNvSpPr>
                <p:nvPr/>
              </p:nvSpPr>
              <p:spPr bwMode="auto">
                <a:xfrm>
                  <a:off x="2928938" y="2822575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9" name="Rectangle 18"/>
                <p:cNvSpPr>
                  <a:spLocks noChangeArrowheads="1"/>
                </p:cNvSpPr>
                <p:nvPr/>
              </p:nvSpPr>
              <p:spPr bwMode="auto">
                <a:xfrm>
                  <a:off x="3433763" y="2822575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0" name="Rectangle 19"/>
                <p:cNvSpPr>
                  <a:spLocks noChangeArrowheads="1"/>
                </p:cNvSpPr>
                <p:nvPr/>
              </p:nvSpPr>
              <p:spPr bwMode="auto">
                <a:xfrm>
                  <a:off x="3824288" y="2822575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5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1" name="Line 20"/>
                <p:cNvSpPr>
                  <a:spLocks noChangeShapeType="1"/>
                </p:cNvSpPr>
                <p:nvPr/>
              </p:nvSpPr>
              <p:spPr bwMode="auto">
                <a:xfrm flipV="1">
                  <a:off x="752475" y="593725"/>
                  <a:ext cx="0" cy="1981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2" name="Line 21"/>
                <p:cNvSpPr>
                  <a:spLocks noChangeShapeType="1"/>
                </p:cNvSpPr>
                <p:nvPr/>
              </p:nvSpPr>
              <p:spPr bwMode="auto">
                <a:xfrm flipH="1">
                  <a:off x="676275" y="2574925"/>
                  <a:ext cx="7620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3" name="Line 22"/>
                <p:cNvSpPr>
                  <a:spLocks noChangeShapeType="1"/>
                </p:cNvSpPr>
                <p:nvPr/>
              </p:nvSpPr>
              <p:spPr bwMode="auto">
                <a:xfrm flipH="1">
                  <a:off x="676275" y="2079625"/>
                  <a:ext cx="7620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4" name="Line 23"/>
                <p:cNvSpPr>
                  <a:spLocks noChangeShapeType="1"/>
                </p:cNvSpPr>
                <p:nvPr/>
              </p:nvSpPr>
              <p:spPr bwMode="auto">
                <a:xfrm flipH="1">
                  <a:off x="676275" y="1584325"/>
                  <a:ext cx="7620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5" name="Line 24"/>
                <p:cNvSpPr>
                  <a:spLocks noChangeShapeType="1"/>
                </p:cNvSpPr>
                <p:nvPr/>
              </p:nvSpPr>
              <p:spPr bwMode="auto">
                <a:xfrm flipH="1">
                  <a:off x="676275" y="1089025"/>
                  <a:ext cx="7620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6" name="Line 25"/>
                <p:cNvSpPr>
                  <a:spLocks noChangeShapeType="1"/>
                </p:cNvSpPr>
                <p:nvPr/>
              </p:nvSpPr>
              <p:spPr bwMode="auto">
                <a:xfrm flipH="1">
                  <a:off x="676275" y="593725"/>
                  <a:ext cx="7620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7" name="Rectangle 26"/>
                <p:cNvSpPr>
                  <a:spLocks noChangeArrowheads="1"/>
                </p:cNvSpPr>
                <p:nvPr/>
              </p:nvSpPr>
              <p:spPr bwMode="auto">
                <a:xfrm rot="16200000">
                  <a:off x="434738" y="2482592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8" name="Rectangle 27"/>
                <p:cNvSpPr>
                  <a:spLocks noChangeArrowheads="1"/>
                </p:cNvSpPr>
                <p:nvPr/>
              </p:nvSpPr>
              <p:spPr bwMode="auto">
                <a:xfrm rot="16200000">
                  <a:off x="434738" y="1987292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1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9" name="Rectangle 28"/>
                <p:cNvSpPr>
                  <a:spLocks noChangeArrowheads="1"/>
                </p:cNvSpPr>
                <p:nvPr/>
              </p:nvSpPr>
              <p:spPr bwMode="auto">
                <a:xfrm rot="16200000">
                  <a:off x="436325" y="1491992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2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0" name="Rectangle 29"/>
                <p:cNvSpPr>
                  <a:spLocks noChangeArrowheads="1"/>
                </p:cNvSpPr>
                <p:nvPr/>
              </p:nvSpPr>
              <p:spPr bwMode="auto">
                <a:xfrm rot="16200000">
                  <a:off x="436325" y="995105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3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" name="Rectangle 30"/>
                <p:cNvSpPr>
                  <a:spLocks noChangeArrowheads="1"/>
                </p:cNvSpPr>
                <p:nvPr/>
              </p:nvSpPr>
              <p:spPr bwMode="auto">
                <a:xfrm rot="16200000">
                  <a:off x="436325" y="499805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4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" name="Rectangle 31"/>
                <p:cNvSpPr>
                  <a:spLocks noChangeArrowheads="1"/>
                </p:cNvSpPr>
                <p:nvPr/>
              </p:nvSpPr>
              <p:spPr bwMode="auto">
                <a:xfrm>
                  <a:off x="752475" y="517525"/>
                  <a:ext cx="3505200" cy="2143125"/>
                </a:xfrm>
                <a:prstGeom prst="rect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3" name="Freeform 34"/>
                <p:cNvSpPr>
                  <a:spLocks/>
                </p:cNvSpPr>
                <p:nvPr/>
              </p:nvSpPr>
              <p:spPr bwMode="auto">
                <a:xfrm>
                  <a:off x="838200" y="2193925"/>
                  <a:ext cx="85725" cy="85725"/>
                </a:xfrm>
                <a:custGeom>
                  <a:avLst/>
                  <a:gdLst>
                    <a:gd name="T0" fmla="*/ 24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24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24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4" name="Freeform 35"/>
                <p:cNvSpPr>
                  <a:spLocks/>
                </p:cNvSpPr>
                <p:nvPr/>
              </p:nvSpPr>
              <p:spPr bwMode="auto">
                <a:xfrm>
                  <a:off x="2667000" y="2012950"/>
                  <a:ext cx="85725" cy="85725"/>
                </a:xfrm>
                <a:custGeom>
                  <a:avLst/>
                  <a:gdLst>
                    <a:gd name="T0" fmla="*/ 30 w 54"/>
                    <a:gd name="T1" fmla="*/ 0 h 54"/>
                    <a:gd name="T2" fmla="*/ 54 w 54"/>
                    <a:gd name="T3" fmla="*/ 54 h 54"/>
                    <a:gd name="T4" fmla="*/ 0 w 54"/>
                    <a:gd name="T5" fmla="*/ 54 h 54"/>
                    <a:gd name="T6" fmla="*/ 30 w 5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54">
                      <a:moveTo>
                        <a:pt x="30" y="0"/>
                      </a:moveTo>
                      <a:lnTo>
                        <a:pt x="54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5" name="Freeform 36"/>
                <p:cNvSpPr>
                  <a:spLocks/>
                </p:cNvSpPr>
                <p:nvPr/>
              </p:nvSpPr>
              <p:spPr bwMode="auto">
                <a:xfrm>
                  <a:off x="4076700" y="2127250"/>
                  <a:ext cx="95250" cy="76200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6" name="Freeform 38"/>
                <p:cNvSpPr>
                  <a:spLocks/>
                </p:cNvSpPr>
                <p:nvPr/>
              </p:nvSpPr>
              <p:spPr bwMode="auto">
                <a:xfrm>
                  <a:off x="838200" y="2184400"/>
                  <a:ext cx="85725" cy="76200"/>
                </a:xfrm>
                <a:custGeom>
                  <a:avLst/>
                  <a:gdLst>
                    <a:gd name="T0" fmla="*/ 4 w 9"/>
                    <a:gd name="T1" fmla="*/ 8 h 8"/>
                    <a:gd name="T2" fmla="*/ 9 w 9"/>
                    <a:gd name="T3" fmla="*/ 0 h 8"/>
                    <a:gd name="T4" fmla="*/ 0 w 9"/>
                    <a:gd name="T5" fmla="*/ 0 h 8"/>
                    <a:gd name="T6" fmla="*/ 4 w 9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9" h="8">
                      <a:moveTo>
                        <a:pt x="4" y="8"/>
                      </a:moveTo>
                      <a:lnTo>
                        <a:pt x="9" y="0"/>
                      </a:lnTo>
                      <a:lnTo>
                        <a:pt x="0" y="0"/>
                      </a:lnTo>
                      <a:lnTo>
                        <a:pt x="4" y="8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7" name="Freeform 39"/>
                <p:cNvSpPr>
                  <a:spLocks/>
                </p:cNvSpPr>
                <p:nvPr/>
              </p:nvSpPr>
              <p:spPr bwMode="auto">
                <a:xfrm>
                  <a:off x="2667000" y="1993900"/>
                  <a:ext cx="85725" cy="76200"/>
                </a:xfrm>
                <a:custGeom>
                  <a:avLst/>
                  <a:gdLst>
                    <a:gd name="T0" fmla="*/ 5 w 9"/>
                    <a:gd name="T1" fmla="*/ 8 h 8"/>
                    <a:gd name="T2" fmla="*/ 9 w 9"/>
                    <a:gd name="T3" fmla="*/ 0 h 8"/>
                    <a:gd name="T4" fmla="*/ 0 w 9"/>
                    <a:gd name="T5" fmla="*/ 0 h 8"/>
                    <a:gd name="T6" fmla="*/ 5 w 9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9" h="8">
                      <a:moveTo>
                        <a:pt x="5" y="8"/>
                      </a:moveTo>
                      <a:lnTo>
                        <a:pt x="9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8" name="Freeform 40"/>
                <p:cNvSpPr>
                  <a:spLocks/>
                </p:cNvSpPr>
                <p:nvPr/>
              </p:nvSpPr>
              <p:spPr bwMode="auto">
                <a:xfrm>
                  <a:off x="4076700" y="2174875"/>
                  <a:ext cx="95250" cy="76200"/>
                </a:xfrm>
                <a:custGeom>
                  <a:avLst/>
                  <a:gdLst>
                    <a:gd name="T0" fmla="*/ 5 w 10"/>
                    <a:gd name="T1" fmla="*/ 8 h 8"/>
                    <a:gd name="T2" fmla="*/ 10 w 10"/>
                    <a:gd name="T3" fmla="*/ 0 h 8"/>
                    <a:gd name="T4" fmla="*/ 0 w 10"/>
                    <a:gd name="T5" fmla="*/ 0 h 8"/>
                    <a:gd name="T6" fmla="*/ 5 w 10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8">
                      <a:moveTo>
                        <a:pt x="5" y="8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9" name="Freeform 42"/>
                <p:cNvSpPr>
                  <a:spLocks noEditPoints="1"/>
                </p:cNvSpPr>
                <p:nvPr/>
              </p:nvSpPr>
              <p:spPr bwMode="auto">
                <a:xfrm>
                  <a:off x="762000" y="2393950"/>
                  <a:ext cx="3495675" cy="0"/>
                </a:xfrm>
                <a:custGeom>
                  <a:avLst/>
                  <a:gdLst>
                    <a:gd name="T0" fmla="*/ 4 w 367"/>
                    <a:gd name="T1" fmla="*/ 11 w 367"/>
                    <a:gd name="T2" fmla="*/ 16 w 367"/>
                    <a:gd name="T3" fmla="*/ 23 w 367"/>
                    <a:gd name="T4" fmla="*/ 28 w 367"/>
                    <a:gd name="T5" fmla="*/ 35 w 367"/>
                    <a:gd name="T6" fmla="*/ 40 w 367"/>
                    <a:gd name="T7" fmla="*/ 47 w 367"/>
                    <a:gd name="T8" fmla="*/ 52 w 367"/>
                    <a:gd name="T9" fmla="*/ 59 w 367"/>
                    <a:gd name="T10" fmla="*/ 64 w 367"/>
                    <a:gd name="T11" fmla="*/ 71 w 367"/>
                    <a:gd name="T12" fmla="*/ 76 w 367"/>
                    <a:gd name="T13" fmla="*/ 83 w 367"/>
                    <a:gd name="T14" fmla="*/ 88 w 367"/>
                    <a:gd name="T15" fmla="*/ 95 w 367"/>
                    <a:gd name="T16" fmla="*/ 100 w 367"/>
                    <a:gd name="T17" fmla="*/ 107 w 367"/>
                    <a:gd name="T18" fmla="*/ 112 w 367"/>
                    <a:gd name="T19" fmla="*/ 119 w 367"/>
                    <a:gd name="T20" fmla="*/ 124 w 367"/>
                    <a:gd name="T21" fmla="*/ 131 w 367"/>
                    <a:gd name="T22" fmla="*/ 136 w 367"/>
                    <a:gd name="T23" fmla="*/ 143 w 367"/>
                    <a:gd name="T24" fmla="*/ 148 w 367"/>
                    <a:gd name="T25" fmla="*/ 155 w 367"/>
                    <a:gd name="T26" fmla="*/ 160 w 367"/>
                    <a:gd name="T27" fmla="*/ 167 w 367"/>
                    <a:gd name="T28" fmla="*/ 172 w 367"/>
                    <a:gd name="T29" fmla="*/ 179 w 367"/>
                    <a:gd name="T30" fmla="*/ 184 w 367"/>
                    <a:gd name="T31" fmla="*/ 191 w 367"/>
                    <a:gd name="T32" fmla="*/ 196 w 367"/>
                    <a:gd name="T33" fmla="*/ 203 w 367"/>
                    <a:gd name="T34" fmla="*/ 208 w 367"/>
                    <a:gd name="T35" fmla="*/ 215 w 367"/>
                    <a:gd name="T36" fmla="*/ 220 w 367"/>
                    <a:gd name="T37" fmla="*/ 227 w 367"/>
                    <a:gd name="T38" fmla="*/ 232 w 367"/>
                    <a:gd name="T39" fmla="*/ 239 w 367"/>
                    <a:gd name="T40" fmla="*/ 244 w 367"/>
                    <a:gd name="T41" fmla="*/ 251 w 367"/>
                    <a:gd name="T42" fmla="*/ 256 w 367"/>
                    <a:gd name="T43" fmla="*/ 263 w 367"/>
                    <a:gd name="T44" fmla="*/ 268 w 367"/>
                    <a:gd name="T45" fmla="*/ 275 w 367"/>
                    <a:gd name="T46" fmla="*/ 280 w 367"/>
                    <a:gd name="T47" fmla="*/ 287 w 367"/>
                    <a:gd name="T48" fmla="*/ 292 w 367"/>
                    <a:gd name="T49" fmla="*/ 299 w 367"/>
                    <a:gd name="T50" fmla="*/ 304 w 367"/>
                    <a:gd name="T51" fmla="*/ 311 w 367"/>
                    <a:gd name="T52" fmla="*/ 316 w 367"/>
                    <a:gd name="T53" fmla="*/ 323 w 367"/>
                    <a:gd name="T54" fmla="*/ 328 w 367"/>
                    <a:gd name="T55" fmla="*/ 335 w 367"/>
                    <a:gd name="T56" fmla="*/ 340 w 367"/>
                    <a:gd name="T57" fmla="*/ 347 w 367"/>
                    <a:gd name="T58" fmla="*/ 352 w 367"/>
                    <a:gd name="T59" fmla="*/ 359 w 367"/>
                    <a:gd name="T60" fmla="*/ 364 w 36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  <a:cxn ang="0">
                      <a:pos x="T59" y="0"/>
                    </a:cxn>
                    <a:cxn ang="0">
                      <a:pos x="T60" y="0"/>
                    </a:cxn>
                  </a:cxnLst>
                  <a:rect l="0" t="0" r="r" b="b"/>
                  <a:pathLst>
                    <a:path w="367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0" name="Freeform 43"/>
                <p:cNvSpPr>
                  <a:spLocks noEditPoints="1"/>
                </p:cNvSpPr>
                <p:nvPr/>
              </p:nvSpPr>
              <p:spPr bwMode="auto">
                <a:xfrm>
                  <a:off x="762000" y="2260600"/>
                  <a:ext cx="3495675" cy="0"/>
                </a:xfrm>
                <a:custGeom>
                  <a:avLst/>
                  <a:gdLst>
                    <a:gd name="T0" fmla="*/ 4 w 367"/>
                    <a:gd name="T1" fmla="*/ 11 w 367"/>
                    <a:gd name="T2" fmla="*/ 16 w 367"/>
                    <a:gd name="T3" fmla="*/ 23 w 367"/>
                    <a:gd name="T4" fmla="*/ 28 w 367"/>
                    <a:gd name="T5" fmla="*/ 35 w 367"/>
                    <a:gd name="T6" fmla="*/ 40 w 367"/>
                    <a:gd name="T7" fmla="*/ 47 w 367"/>
                    <a:gd name="T8" fmla="*/ 52 w 367"/>
                    <a:gd name="T9" fmla="*/ 59 w 367"/>
                    <a:gd name="T10" fmla="*/ 64 w 367"/>
                    <a:gd name="T11" fmla="*/ 71 w 367"/>
                    <a:gd name="T12" fmla="*/ 76 w 367"/>
                    <a:gd name="T13" fmla="*/ 83 w 367"/>
                    <a:gd name="T14" fmla="*/ 88 w 367"/>
                    <a:gd name="T15" fmla="*/ 95 w 367"/>
                    <a:gd name="T16" fmla="*/ 100 w 367"/>
                    <a:gd name="T17" fmla="*/ 107 w 367"/>
                    <a:gd name="T18" fmla="*/ 112 w 367"/>
                    <a:gd name="T19" fmla="*/ 119 w 367"/>
                    <a:gd name="T20" fmla="*/ 124 w 367"/>
                    <a:gd name="T21" fmla="*/ 131 w 367"/>
                    <a:gd name="T22" fmla="*/ 136 w 367"/>
                    <a:gd name="T23" fmla="*/ 143 w 367"/>
                    <a:gd name="T24" fmla="*/ 148 w 367"/>
                    <a:gd name="T25" fmla="*/ 155 w 367"/>
                    <a:gd name="T26" fmla="*/ 160 w 367"/>
                    <a:gd name="T27" fmla="*/ 167 w 367"/>
                    <a:gd name="T28" fmla="*/ 172 w 367"/>
                    <a:gd name="T29" fmla="*/ 179 w 367"/>
                    <a:gd name="T30" fmla="*/ 184 w 367"/>
                    <a:gd name="T31" fmla="*/ 191 w 367"/>
                    <a:gd name="T32" fmla="*/ 196 w 367"/>
                    <a:gd name="T33" fmla="*/ 203 w 367"/>
                    <a:gd name="T34" fmla="*/ 208 w 367"/>
                    <a:gd name="T35" fmla="*/ 215 w 367"/>
                    <a:gd name="T36" fmla="*/ 220 w 367"/>
                    <a:gd name="T37" fmla="*/ 227 w 367"/>
                    <a:gd name="T38" fmla="*/ 232 w 367"/>
                    <a:gd name="T39" fmla="*/ 239 w 367"/>
                    <a:gd name="T40" fmla="*/ 244 w 367"/>
                    <a:gd name="T41" fmla="*/ 251 w 367"/>
                    <a:gd name="T42" fmla="*/ 256 w 367"/>
                    <a:gd name="T43" fmla="*/ 263 w 367"/>
                    <a:gd name="T44" fmla="*/ 268 w 367"/>
                    <a:gd name="T45" fmla="*/ 275 w 367"/>
                    <a:gd name="T46" fmla="*/ 280 w 367"/>
                    <a:gd name="T47" fmla="*/ 287 w 367"/>
                    <a:gd name="T48" fmla="*/ 292 w 367"/>
                    <a:gd name="T49" fmla="*/ 299 w 367"/>
                    <a:gd name="T50" fmla="*/ 304 w 367"/>
                    <a:gd name="T51" fmla="*/ 311 w 367"/>
                    <a:gd name="T52" fmla="*/ 316 w 367"/>
                    <a:gd name="T53" fmla="*/ 323 w 367"/>
                    <a:gd name="T54" fmla="*/ 328 w 367"/>
                    <a:gd name="T55" fmla="*/ 335 w 367"/>
                    <a:gd name="T56" fmla="*/ 340 w 367"/>
                    <a:gd name="T57" fmla="*/ 347 w 367"/>
                    <a:gd name="T58" fmla="*/ 352 w 367"/>
                    <a:gd name="T59" fmla="*/ 359 w 367"/>
                    <a:gd name="T60" fmla="*/ 364 w 36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  <a:cxn ang="0">
                      <a:pos x="T59" y="0"/>
                    </a:cxn>
                    <a:cxn ang="0">
                      <a:pos x="T60" y="0"/>
                    </a:cxn>
                  </a:cxnLst>
                  <a:rect l="0" t="0" r="r" b="b"/>
                  <a:pathLst>
                    <a:path w="367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grpSp>
            <p:nvGrpSpPr>
              <p:cNvPr id="14" name="Group 13"/>
              <p:cNvGrpSpPr/>
              <p:nvPr/>
            </p:nvGrpSpPr>
            <p:grpSpPr>
              <a:xfrm>
                <a:off x="5049837" y="771030"/>
                <a:ext cx="3807083" cy="2429370"/>
                <a:chOff x="4889242" y="485538"/>
                <a:chExt cx="3807083" cy="2521703"/>
              </a:xfrm>
            </p:grpSpPr>
            <p:sp>
              <p:nvSpPr>
                <p:cNvPr id="83" name="Freeform 44"/>
                <p:cNvSpPr>
                  <a:spLocks/>
                </p:cNvSpPr>
                <p:nvPr/>
              </p:nvSpPr>
              <p:spPr bwMode="auto">
                <a:xfrm>
                  <a:off x="5286375" y="2393950"/>
                  <a:ext cx="76200" cy="66675"/>
                </a:xfrm>
                <a:custGeom>
                  <a:avLst/>
                  <a:gdLst>
                    <a:gd name="T0" fmla="*/ 24 w 48"/>
                    <a:gd name="T1" fmla="*/ 0 h 42"/>
                    <a:gd name="T2" fmla="*/ 48 w 48"/>
                    <a:gd name="T3" fmla="*/ 42 h 42"/>
                    <a:gd name="T4" fmla="*/ 0 w 48"/>
                    <a:gd name="T5" fmla="*/ 42 h 42"/>
                    <a:gd name="T6" fmla="*/ 24 w 48"/>
                    <a:gd name="T7" fmla="*/ 0 h 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8" h="42">
                      <a:moveTo>
                        <a:pt x="24" y="0"/>
                      </a:moveTo>
                      <a:lnTo>
                        <a:pt x="48" y="42"/>
                      </a:lnTo>
                      <a:lnTo>
                        <a:pt x="0" y="42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" name="Freeform 45"/>
                <p:cNvSpPr>
                  <a:spLocks/>
                </p:cNvSpPr>
                <p:nvPr/>
              </p:nvSpPr>
              <p:spPr bwMode="auto">
                <a:xfrm>
                  <a:off x="7115175" y="2327275"/>
                  <a:ext cx="76200" cy="66675"/>
                </a:xfrm>
                <a:custGeom>
                  <a:avLst/>
                  <a:gdLst>
                    <a:gd name="T0" fmla="*/ 24 w 48"/>
                    <a:gd name="T1" fmla="*/ 0 h 42"/>
                    <a:gd name="T2" fmla="*/ 48 w 48"/>
                    <a:gd name="T3" fmla="*/ 42 h 42"/>
                    <a:gd name="T4" fmla="*/ 0 w 48"/>
                    <a:gd name="T5" fmla="*/ 42 h 42"/>
                    <a:gd name="T6" fmla="*/ 24 w 48"/>
                    <a:gd name="T7" fmla="*/ 0 h 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8" h="42">
                      <a:moveTo>
                        <a:pt x="24" y="0"/>
                      </a:moveTo>
                      <a:lnTo>
                        <a:pt x="48" y="42"/>
                      </a:lnTo>
                      <a:lnTo>
                        <a:pt x="0" y="42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" name="Freeform 46"/>
                <p:cNvSpPr>
                  <a:spLocks/>
                </p:cNvSpPr>
                <p:nvPr/>
              </p:nvSpPr>
              <p:spPr bwMode="auto">
                <a:xfrm>
                  <a:off x="8524875" y="2422525"/>
                  <a:ext cx="76200" cy="66675"/>
                </a:xfrm>
                <a:custGeom>
                  <a:avLst/>
                  <a:gdLst>
                    <a:gd name="T0" fmla="*/ 24 w 48"/>
                    <a:gd name="T1" fmla="*/ 0 h 42"/>
                    <a:gd name="T2" fmla="*/ 48 w 48"/>
                    <a:gd name="T3" fmla="*/ 42 h 42"/>
                    <a:gd name="T4" fmla="*/ 0 w 48"/>
                    <a:gd name="T5" fmla="*/ 42 h 42"/>
                    <a:gd name="T6" fmla="*/ 24 w 48"/>
                    <a:gd name="T7" fmla="*/ 0 h 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8" h="42">
                      <a:moveTo>
                        <a:pt x="24" y="0"/>
                      </a:moveTo>
                      <a:lnTo>
                        <a:pt x="48" y="42"/>
                      </a:lnTo>
                      <a:lnTo>
                        <a:pt x="0" y="42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" name="Line 47"/>
                <p:cNvSpPr>
                  <a:spLocks noChangeShapeType="1"/>
                </p:cNvSpPr>
                <p:nvPr/>
              </p:nvSpPr>
              <p:spPr bwMode="auto">
                <a:xfrm>
                  <a:off x="5629275" y="2660650"/>
                  <a:ext cx="280035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" name="Line 48"/>
                <p:cNvSpPr>
                  <a:spLocks noChangeShapeType="1"/>
                </p:cNvSpPr>
                <p:nvPr/>
              </p:nvSpPr>
              <p:spPr bwMode="auto">
                <a:xfrm>
                  <a:off x="5629275" y="2660650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" name="Line 49"/>
                <p:cNvSpPr>
                  <a:spLocks noChangeShapeType="1"/>
                </p:cNvSpPr>
                <p:nvPr/>
              </p:nvSpPr>
              <p:spPr bwMode="auto">
                <a:xfrm>
                  <a:off x="6838950" y="2660650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" name="Line 50"/>
                <p:cNvSpPr>
                  <a:spLocks noChangeShapeType="1"/>
                </p:cNvSpPr>
                <p:nvPr/>
              </p:nvSpPr>
              <p:spPr bwMode="auto">
                <a:xfrm>
                  <a:off x="7543800" y="2660650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" name="Line 51"/>
                <p:cNvSpPr>
                  <a:spLocks noChangeShapeType="1"/>
                </p:cNvSpPr>
                <p:nvPr/>
              </p:nvSpPr>
              <p:spPr bwMode="auto">
                <a:xfrm>
                  <a:off x="8048625" y="2660650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" name="Line 52"/>
                <p:cNvSpPr>
                  <a:spLocks noChangeShapeType="1"/>
                </p:cNvSpPr>
                <p:nvPr/>
              </p:nvSpPr>
              <p:spPr bwMode="auto">
                <a:xfrm>
                  <a:off x="8429625" y="2660650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" name="Rectangle 53"/>
                <p:cNvSpPr>
                  <a:spLocks noChangeArrowheads="1"/>
                </p:cNvSpPr>
                <p:nvPr/>
              </p:nvSpPr>
              <p:spPr bwMode="auto">
                <a:xfrm>
                  <a:off x="5462588" y="2822575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" name="Rectangle 54"/>
                <p:cNvSpPr>
                  <a:spLocks noChangeArrowheads="1"/>
                </p:cNvSpPr>
                <p:nvPr/>
              </p:nvSpPr>
              <p:spPr bwMode="auto">
                <a:xfrm>
                  <a:off x="6672263" y="2822575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" name="Rectangle 55"/>
                <p:cNvSpPr>
                  <a:spLocks noChangeArrowheads="1"/>
                </p:cNvSpPr>
                <p:nvPr/>
              </p:nvSpPr>
              <p:spPr bwMode="auto">
                <a:xfrm>
                  <a:off x="7377113" y="2822575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5" name="Rectangle 56"/>
                <p:cNvSpPr>
                  <a:spLocks noChangeArrowheads="1"/>
                </p:cNvSpPr>
                <p:nvPr/>
              </p:nvSpPr>
              <p:spPr bwMode="auto">
                <a:xfrm>
                  <a:off x="7881938" y="2822575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6" name="Rectangle 57"/>
                <p:cNvSpPr>
                  <a:spLocks noChangeArrowheads="1"/>
                </p:cNvSpPr>
                <p:nvPr/>
              </p:nvSpPr>
              <p:spPr bwMode="auto">
                <a:xfrm>
                  <a:off x="8262938" y="2822575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5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7" name="Line 58"/>
                <p:cNvSpPr>
                  <a:spLocks noChangeShapeType="1"/>
                </p:cNvSpPr>
                <p:nvPr/>
              </p:nvSpPr>
              <p:spPr bwMode="auto">
                <a:xfrm flipV="1">
                  <a:off x="5191125" y="593725"/>
                  <a:ext cx="0" cy="1981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8" name="Line 59"/>
                <p:cNvSpPr>
                  <a:spLocks noChangeShapeType="1"/>
                </p:cNvSpPr>
                <p:nvPr/>
              </p:nvSpPr>
              <p:spPr bwMode="auto">
                <a:xfrm flipH="1">
                  <a:off x="5114925" y="2574925"/>
                  <a:ext cx="7620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9" name="Line 60"/>
                <p:cNvSpPr>
                  <a:spLocks noChangeShapeType="1"/>
                </p:cNvSpPr>
                <p:nvPr/>
              </p:nvSpPr>
              <p:spPr bwMode="auto">
                <a:xfrm flipH="1">
                  <a:off x="5114925" y="2079625"/>
                  <a:ext cx="7620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0" name="Line 61"/>
                <p:cNvSpPr>
                  <a:spLocks noChangeShapeType="1"/>
                </p:cNvSpPr>
                <p:nvPr/>
              </p:nvSpPr>
              <p:spPr bwMode="auto">
                <a:xfrm flipH="1">
                  <a:off x="5114925" y="1584325"/>
                  <a:ext cx="7620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1" name="Line 62"/>
                <p:cNvSpPr>
                  <a:spLocks noChangeShapeType="1"/>
                </p:cNvSpPr>
                <p:nvPr/>
              </p:nvSpPr>
              <p:spPr bwMode="auto">
                <a:xfrm flipH="1">
                  <a:off x="5114925" y="1089025"/>
                  <a:ext cx="7620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2" name="Line 63"/>
                <p:cNvSpPr>
                  <a:spLocks noChangeShapeType="1"/>
                </p:cNvSpPr>
                <p:nvPr/>
              </p:nvSpPr>
              <p:spPr bwMode="auto">
                <a:xfrm flipH="1">
                  <a:off x="5114925" y="593725"/>
                  <a:ext cx="7620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3" name="Rectangle 64"/>
                <p:cNvSpPr>
                  <a:spLocks noChangeArrowheads="1"/>
                </p:cNvSpPr>
                <p:nvPr/>
              </p:nvSpPr>
              <p:spPr bwMode="auto">
                <a:xfrm rot="16200000">
                  <a:off x="4874975" y="2481005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4" name="Rectangle 65"/>
                <p:cNvSpPr>
                  <a:spLocks noChangeArrowheads="1"/>
                </p:cNvSpPr>
                <p:nvPr/>
              </p:nvSpPr>
              <p:spPr bwMode="auto">
                <a:xfrm rot="16200000">
                  <a:off x="4874975" y="1985705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1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5" name="Rectangle 66"/>
                <p:cNvSpPr>
                  <a:spLocks noChangeArrowheads="1"/>
                </p:cNvSpPr>
                <p:nvPr/>
              </p:nvSpPr>
              <p:spPr bwMode="auto">
                <a:xfrm rot="16200000">
                  <a:off x="4874975" y="1490405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2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6" name="Rectangle 67"/>
                <p:cNvSpPr>
                  <a:spLocks noChangeArrowheads="1"/>
                </p:cNvSpPr>
                <p:nvPr/>
              </p:nvSpPr>
              <p:spPr bwMode="auto">
                <a:xfrm rot="16200000">
                  <a:off x="4874975" y="995105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3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7" name="Rectangle 68"/>
                <p:cNvSpPr>
                  <a:spLocks noChangeArrowheads="1"/>
                </p:cNvSpPr>
                <p:nvPr/>
              </p:nvSpPr>
              <p:spPr bwMode="auto">
                <a:xfrm rot="16200000">
                  <a:off x="4874975" y="499805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4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8" name="Rectangle 69"/>
                <p:cNvSpPr>
                  <a:spLocks noChangeArrowheads="1"/>
                </p:cNvSpPr>
                <p:nvPr/>
              </p:nvSpPr>
              <p:spPr bwMode="auto">
                <a:xfrm>
                  <a:off x="5191125" y="517525"/>
                  <a:ext cx="3505200" cy="2143125"/>
                </a:xfrm>
                <a:prstGeom prst="rect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9" name="Freeform 72"/>
                <p:cNvSpPr>
                  <a:spLocks/>
                </p:cNvSpPr>
                <p:nvPr/>
              </p:nvSpPr>
              <p:spPr bwMode="auto">
                <a:xfrm>
                  <a:off x="5276850" y="2384425"/>
                  <a:ext cx="95250" cy="85725"/>
                </a:xfrm>
                <a:custGeom>
                  <a:avLst/>
                  <a:gdLst>
                    <a:gd name="T0" fmla="*/ 30 w 60"/>
                    <a:gd name="T1" fmla="*/ 0 h 54"/>
                    <a:gd name="T2" fmla="*/ 60 w 60"/>
                    <a:gd name="T3" fmla="*/ 54 h 54"/>
                    <a:gd name="T4" fmla="*/ 0 w 60"/>
                    <a:gd name="T5" fmla="*/ 54 h 54"/>
                    <a:gd name="T6" fmla="*/ 30 w 60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54">
                      <a:moveTo>
                        <a:pt x="30" y="0"/>
                      </a:moveTo>
                      <a:lnTo>
                        <a:pt x="60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10" name="Freeform 73"/>
                <p:cNvSpPr>
                  <a:spLocks/>
                </p:cNvSpPr>
                <p:nvPr/>
              </p:nvSpPr>
              <p:spPr bwMode="auto">
                <a:xfrm>
                  <a:off x="7105650" y="2317750"/>
                  <a:ext cx="95250" cy="76200"/>
                </a:xfrm>
                <a:custGeom>
                  <a:avLst/>
                  <a:gdLst>
                    <a:gd name="T0" fmla="*/ 30 w 60"/>
                    <a:gd name="T1" fmla="*/ 0 h 48"/>
                    <a:gd name="T2" fmla="*/ 60 w 60"/>
                    <a:gd name="T3" fmla="*/ 48 h 48"/>
                    <a:gd name="T4" fmla="*/ 0 w 60"/>
                    <a:gd name="T5" fmla="*/ 48 h 48"/>
                    <a:gd name="T6" fmla="*/ 30 w 60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48">
                      <a:moveTo>
                        <a:pt x="30" y="0"/>
                      </a:moveTo>
                      <a:lnTo>
                        <a:pt x="60" y="48"/>
                      </a:lnTo>
                      <a:lnTo>
                        <a:pt x="0" y="48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11" name="Freeform 74"/>
                <p:cNvSpPr>
                  <a:spLocks/>
                </p:cNvSpPr>
                <p:nvPr/>
              </p:nvSpPr>
              <p:spPr bwMode="auto">
                <a:xfrm>
                  <a:off x="8524875" y="2413000"/>
                  <a:ext cx="85725" cy="76200"/>
                </a:xfrm>
                <a:custGeom>
                  <a:avLst/>
                  <a:gdLst>
                    <a:gd name="T0" fmla="*/ 24 w 54"/>
                    <a:gd name="T1" fmla="*/ 0 h 48"/>
                    <a:gd name="T2" fmla="*/ 54 w 54"/>
                    <a:gd name="T3" fmla="*/ 48 h 48"/>
                    <a:gd name="T4" fmla="*/ 0 w 54"/>
                    <a:gd name="T5" fmla="*/ 48 h 48"/>
                    <a:gd name="T6" fmla="*/ 24 w 5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4" h="48">
                      <a:moveTo>
                        <a:pt x="24" y="0"/>
                      </a:moveTo>
                      <a:lnTo>
                        <a:pt x="54" y="48"/>
                      </a:lnTo>
                      <a:lnTo>
                        <a:pt x="0" y="48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12" name="Freeform 76"/>
                <p:cNvSpPr>
                  <a:spLocks/>
                </p:cNvSpPr>
                <p:nvPr/>
              </p:nvSpPr>
              <p:spPr bwMode="auto">
                <a:xfrm>
                  <a:off x="5276850" y="2184400"/>
                  <a:ext cx="95250" cy="76200"/>
                </a:xfrm>
                <a:custGeom>
                  <a:avLst/>
                  <a:gdLst>
                    <a:gd name="T0" fmla="*/ 5 w 10"/>
                    <a:gd name="T1" fmla="*/ 8 h 8"/>
                    <a:gd name="T2" fmla="*/ 10 w 10"/>
                    <a:gd name="T3" fmla="*/ 0 h 8"/>
                    <a:gd name="T4" fmla="*/ 0 w 10"/>
                    <a:gd name="T5" fmla="*/ 0 h 8"/>
                    <a:gd name="T6" fmla="*/ 5 w 10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8">
                      <a:moveTo>
                        <a:pt x="5" y="8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13" name="Freeform 77"/>
                <p:cNvSpPr>
                  <a:spLocks/>
                </p:cNvSpPr>
                <p:nvPr/>
              </p:nvSpPr>
              <p:spPr bwMode="auto">
                <a:xfrm>
                  <a:off x="7105650" y="2136775"/>
                  <a:ext cx="95250" cy="76200"/>
                </a:xfrm>
                <a:custGeom>
                  <a:avLst/>
                  <a:gdLst>
                    <a:gd name="T0" fmla="*/ 5 w 10"/>
                    <a:gd name="T1" fmla="*/ 8 h 8"/>
                    <a:gd name="T2" fmla="*/ 10 w 10"/>
                    <a:gd name="T3" fmla="*/ 0 h 8"/>
                    <a:gd name="T4" fmla="*/ 0 w 10"/>
                    <a:gd name="T5" fmla="*/ 0 h 8"/>
                    <a:gd name="T6" fmla="*/ 5 w 10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8">
                      <a:moveTo>
                        <a:pt x="5" y="8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14" name="Freeform 78"/>
                <p:cNvSpPr>
                  <a:spLocks/>
                </p:cNvSpPr>
                <p:nvPr/>
              </p:nvSpPr>
              <p:spPr bwMode="auto">
                <a:xfrm>
                  <a:off x="8524875" y="2241550"/>
                  <a:ext cx="85725" cy="85725"/>
                </a:xfrm>
                <a:custGeom>
                  <a:avLst/>
                  <a:gdLst>
                    <a:gd name="T0" fmla="*/ 4 w 9"/>
                    <a:gd name="T1" fmla="*/ 9 h 9"/>
                    <a:gd name="T2" fmla="*/ 9 w 9"/>
                    <a:gd name="T3" fmla="*/ 0 h 9"/>
                    <a:gd name="T4" fmla="*/ 0 w 9"/>
                    <a:gd name="T5" fmla="*/ 0 h 9"/>
                    <a:gd name="T6" fmla="*/ 4 w 9"/>
                    <a:gd name="T7" fmla="*/ 9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9" h="9">
                      <a:moveTo>
                        <a:pt x="4" y="9"/>
                      </a:moveTo>
                      <a:lnTo>
                        <a:pt x="9" y="0"/>
                      </a:lnTo>
                      <a:lnTo>
                        <a:pt x="0" y="0"/>
                      </a:lnTo>
                      <a:lnTo>
                        <a:pt x="4" y="9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15" name="Freeform 80"/>
                <p:cNvSpPr>
                  <a:spLocks noEditPoints="1"/>
                </p:cNvSpPr>
                <p:nvPr/>
              </p:nvSpPr>
              <p:spPr bwMode="auto">
                <a:xfrm>
                  <a:off x="5200650" y="2393950"/>
                  <a:ext cx="3495675" cy="0"/>
                </a:xfrm>
                <a:custGeom>
                  <a:avLst/>
                  <a:gdLst>
                    <a:gd name="T0" fmla="*/ 4 w 367"/>
                    <a:gd name="T1" fmla="*/ 11 w 367"/>
                    <a:gd name="T2" fmla="*/ 16 w 367"/>
                    <a:gd name="T3" fmla="*/ 23 w 367"/>
                    <a:gd name="T4" fmla="*/ 28 w 367"/>
                    <a:gd name="T5" fmla="*/ 35 w 367"/>
                    <a:gd name="T6" fmla="*/ 40 w 367"/>
                    <a:gd name="T7" fmla="*/ 47 w 367"/>
                    <a:gd name="T8" fmla="*/ 52 w 367"/>
                    <a:gd name="T9" fmla="*/ 59 w 367"/>
                    <a:gd name="T10" fmla="*/ 64 w 367"/>
                    <a:gd name="T11" fmla="*/ 71 w 367"/>
                    <a:gd name="T12" fmla="*/ 76 w 367"/>
                    <a:gd name="T13" fmla="*/ 83 w 367"/>
                    <a:gd name="T14" fmla="*/ 88 w 367"/>
                    <a:gd name="T15" fmla="*/ 95 w 367"/>
                    <a:gd name="T16" fmla="*/ 100 w 367"/>
                    <a:gd name="T17" fmla="*/ 107 w 367"/>
                    <a:gd name="T18" fmla="*/ 112 w 367"/>
                    <a:gd name="T19" fmla="*/ 119 w 367"/>
                    <a:gd name="T20" fmla="*/ 124 w 367"/>
                    <a:gd name="T21" fmla="*/ 131 w 367"/>
                    <a:gd name="T22" fmla="*/ 136 w 367"/>
                    <a:gd name="T23" fmla="*/ 143 w 367"/>
                    <a:gd name="T24" fmla="*/ 148 w 367"/>
                    <a:gd name="T25" fmla="*/ 155 w 367"/>
                    <a:gd name="T26" fmla="*/ 160 w 367"/>
                    <a:gd name="T27" fmla="*/ 167 w 367"/>
                    <a:gd name="T28" fmla="*/ 172 w 367"/>
                    <a:gd name="T29" fmla="*/ 179 w 367"/>
                    <a:gd name="T30" fmla="*/ 184 w 367"/>
                    <a:gd name="T31" fmla="*/ 191 w 367"/>
                    <a:gd name="T32" fmla="*/ 196 w 367"/>
                    <a:gd name="T33" fmla="*/ 203 w 367"/>
                    <a:gd name="T34" fmla="*/ 208 w 367"/>
                    <a:gd name="T35" fmla="*/ 215 w 367"/>
                    <a:gd name="T36" fmla="*/ 220 w 367"/>
                    <a:gd name="T37" fmla="*/ 227 w 367"/>
                    <a:gd name="T38" fmla="*/ 232 w 367"/>
                    <a:gd name="T39" fmla="*/ 239 w 367"/>
                    <a:gd name="T40" fmla="*/ 244 w 367"/>
                    <a:gd name="T41" fmla="*/ 251 w 367"/>
                    <a:gd name="T42" fmla="*/ 256 w 367"/>
                    <a:gd name="T43" fmla="*/ 263 w 367"/>
                    <a:gd name="T44" fmla="*/ 268 w 367"/>
                    <a:gd name="T45" fmla="*/ 275 w 367"/>
                    <a:gd name="T46" fmla="*/ 280 w 367"/>
                    <a:gd name="T47" fmla="*/ 287 w 367"/>
                    <a:gd name="T48" fmla="*/ 292 w 367"/>
                    <a:gd name="T49" fmla="*/ 299 w 367"/>
                    <a:gd name="T50" fmla="*/ 304 w 367"/>
                    <a:gd name="T51" fmla="*/ 311 w 367"/>
                    <a:gd name="T52" fmla="*/ 316 w 367"/>
                    <a:gd name="T53" fmla="*/ 323 w 367"/>
                    <a:gd name="T54" fmla="*/ 328 w 367"/>
                    <a:gd name="T55" fmla="*/ 335 w 367"/>
                    <a:gd name="T56" fmla="*/ 340 w 367"/>
                    <a:gd name="T57" fmla="*/ 347 w 367"/>
                    <a:gd name="T58" fmla="*/ 352 w 367"/>
                    <a:gd name="T59" fmla="*/ 359 w 367"/>
                    <a:gd name="T60" fmla="*/ 364 w 36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  <a:cxn ang="0">
                      <a:pos x="T59" y="0"/>
                    </a:cxn>
                    <a:cxn ang="0">
                      <a:pos x="T60" y="0"/>
                    </a:cxn>
                  </a:cxnLst>
                  <a:rect l="0" t="0" r="r" b="b"/>
                  <a:pathLst>
                    <a:path w="367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16" name="Freeform 81"/>
                <p:cNvSpPr>
                  <a:spLocks noEditPoints="1"/>
                </p:cNvSpPr>
                <p:nvPr/>
              </p:nvSpPr>
              <p:spPr bwMode="auto">
                <a:xfrm>
                  <a:off x="5200650" y="2260600"/>
                  <a:ext cx="3495675" cy="0"/>
                </a:xfrm>
                <a:custGeom>
                  <a:avLst/>
                  <a:gdLst>
                    <a:gd name="T0" fmla="*/ 4 w 367"/>
                    <a:gd name="T1" fmla="*/ 11 w 367"/>
                    <a:gd name="T2" fmla="*/ 16 w 367"/>
                    <a:gd name="T3" fmla="*/ 23 w 367"/>
                    <a:gd name="T4" fmla="*/ 28 w 367"/>
                    <a:gd name="T5" fmla="*/ 35 w 367"/>
                    <a:gd name="T6" fmla="*/ 40 w 367"/>
                    <a:gd name="T7" fmla="*/ 47 w 367"/>
                    <a:gd name="T8" fmla="*/ 52 w 367"/>
                    <a:gd name="T9" fmla="*/ 59 w 367"/>
                    <a:gd name="T10" fmla="*/ 64 w 367"/>
                    <a:gd name="T11" fmla="*/ 71 w 367"/>
                    <a:gd name="T12" fmla="*/ 76 w 367"/>
                    <a:gd name="T13" fmla="*/ 83 w 367"/>
                    <a:gd name="T14" fmla="*/ 88 w 367"/>
                    <a:gd name="T15" fmla="*/ 95 w 367"/>
                    <a:gd name="T16" fmla="*/ 100 w 367"/>
                    <a:gd name="T17" fmla="*/ 107 w 367"/>
                    <a:gd name="T18" fmla="*/ 112 w 367"/>
                    <a:gd name="T19" fmla="*/ 119 w 367"/>
                    <a:gd name="T20" fmla="*/ 124 w 367"/>
                    <a:gd name="T21" fmla="*/ 131 w 367"/>
                    <a:gd name="T22" fmla="*/ 136 w 367"/>
                    <a:gd name="T23" fmla="*/ 143 w 367"/>
                    <a:gd name="T24" fmla="*/ 148 w 367"/>
                    <a:gd name="T25" fmla="*/ 155 w 367"/>
                    <a:gd name="T26" fmla="*/ 160 w 367"/>
                    <a:gd name="T27" fmla="*/ 167 w 367"/>
                    <a:gd name="T28" fmla="*/ 172 w 367"/>
                    <a:gd name="T29" fmla="*/ 179 w 367"/>
                    <a:gd name="T30" fmla="*/ 184 w 367"/>
                    <a:gd name="T31" fmla="*/ 191 w 367"/>
                    <a:gd name="T32" fmla="*/ 196 w 367"/>
                    <a:gd name="T33" fmla="*/ 203 w 367"/>
                    <a:gd name="T34" fmla="*/ 208 w 367"/>
                    <a:gd name="T35" fmla="*/ 215 w 367"/>
                    <a:gd name="T36" fmla="*/ 220 w 367"/>
                    <a:gd name="T37" fmla="*/ 227 w 367"/>
                    <a:gd name="T38" fmla="*/ 232 w 367"/>
                    <a:gd name="T39" fmla="*/ 239 w 367"/>
                    <a:gd name="T40" fmla="*/ 244 w 367"/>
                    <a:gd name="T41" fmla="*/ 251 w 367"/>
                    <a:gd name="T42" fmla="*/ 256 w 367"/>
                    <a:gd name="T43" fmla="*/ 263 w 367"/>
                    <a:gd name="T44" fmla="*/ 268 w 367"/>
                    <a:gd name="T45" fmla="*/ 275 w 367"/>
                    <a:gd name="T46" fmla="*/ 280 w 367"/>
                    <a:gd name="T47" fmla="*/ 287 w 367"/>
                    <a:gd name="T48" fmla="*/ 292 w 367"/>
                    <a:gd name="T49" fmla="*/ 299 w 367"/>
                    <a:gd name="T50" fmla="*/ 304 w 367"/>
                    <a:gd name="T51" fmla="*/ 311 w 367"/>
                    <a:gd name="T52" fmla="*/ 316 w 367"/>
                    <a:gd name="T53" fmla="*/ 323 w 367"/>
                    <a:gd name="T54" fmla="*/ 328 w 367"/>
                    <a:gd name="T55" fmla="*/ 335 w 367"/>
                    <a:gd name="T56" fmla="*/ 340 w 367"/>
                    <a:gd name="T57" fmla="*/ 347 w 367"/>
                    <a:gd name="T58" fmla="*/ 352 w 367"/>
                    <a:gd name="T59" fmla="*/ 359 w 367"/>
                    <a:gd name="T60" fmla="*/ 364 w 36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  <a:cxn ang="0">
                      <a:pos x="T59" y="0"/>
                    </a:cxn>
                    <a:cxn ang="0">
                      <a:pos x="T60" y="0"/>
                    </a:cxn>
                  </a:cxnLst>
                  <a:rect l="0" t="0" r="r" b="b"/>
                  <a:pathLst>
                    <a:path w="367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grpSp>
            <p:nvGrpSpPr>
              <p:cNvPr id="15" name="Group 14"/>
              <p:cNvGrpSpPr/>
              <p:nvPr/>
            </p:nvGrpSpPr>
            <p:grpSpPr>
              <a:xfrm>
                <a:off x="609600" y="3666656"/>
                <a:ext cx="3861481" cy="2353144"/>
                <a:chOff x="496629" y="3560525"/>
                <a:chExt cx="3703897" cy="2537579"/>
              </a:xfrm>
            </p:grpSpPr>
            <p:sp>
              <p:nvSpPr>
                <p:cNvPr id="50" name="Freeform 86"/>
                <p:cNvSpPr>
                  <a:spLocks/>
                </p:cNvSpPr>
                <p:nvPr/>
              </p:nvSpPr>
              <p:spPr bwMode="auto">
                <a:xfrm>
                  <a:off x="877888" y="5487988"/>
                  <a:ext cx="90488" cy="66675"/>
                </a:xfrm>
                <a:custGeom>
                  <a:avLst/>
                  <a:gdLst>
                    <a:gd name="T0" fmla="*/ 32 w 57"/>
                    <a:gd name="T1" fmla="*/ 0 h 42"/>
                    <a:gd name="T2" fmla="*/ 57 w 57"/>
                    <a:gd name="T3" fmla="*/ 42 h 42"/>
                    <a:gd name="T4" fmla="*/ 0 w 57"/>
                    <a:gd name="T5" fmla="*/ 42 h 42"/>
                    <a:gd name="T6" fmla="*/ 32 w 57"/>
                    <a:gd name="T7" fmla="*/ 0 h 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7" h="42">
                      <a:moveTo>
                        <a:pt x="32" y="0"/>
                      </a:moveTo>
                      <a:lnTo>
                        <a:pt x="57" y="42"/>
                      </a:lnTo>
                      <a:lnTo>
                        <a:pt x="0" y="42"/>
                      </a:lnTo>
                      <a:lnTo>
                        <a:pt x="32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51" name="Freeform 87"/>
                <p:cNvSpPr>
                  <a:spLocks/>
                </p:cNvSpPr>
                <p:nvPr/>
              </p:nvSpPr>
              <p:spPr bwMode="auto">
                <a:xfrm>
                  <a:off x="2659063" y="5354638"/>
                  <a:ext cx="79375" cy="66675"/>
                </a:xfrm>
                <a:custGeom>
                  <a:avLst/>
                  <a:gdLst>
                    <a:gd name="T0" fmla="*/ 25 w 50"/>
                    <a:gd name="T1" fmla="*/ 0 h 42"/>
                    <a:gd name="T2" fmla="*/ 50 w 50"/>
                    <a:gd name="T3" fmla="*/ 42 h 42"/>
                    <a:gd name="T4" fmla="*/ 0 w 50"/>
                    <a:gd name="T5" fmla="*/ 42 h 42"/>
                    <a:gd name="T6" fmla="*/ 25 w 50"/>
                    <a:gd name="T7" fmla="*/ 0 h 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0" h="42">
                      <a:moveTo>
                        <a:pt x="25" y="0"/>
                      </a:moveTo>
                      <a:lnTo>
                        <a:pt x="50" y="42"/>
                      </a:lnTo>
                      <a:lnTo>
                        <a:pt x="0" y="42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52" name="Freeform 88"/>
                <p:cNvSpPr>
                  <a:spLocks/>
                </p:cNvSpPr>
                <p:nvPr/>
              </p:nvSpPr>
              <p:spPr bwMode="auto">
                <a:xfrm>
                  <a:off x="4032250" y="5260975"/>
                  <a:ext cx="79375" cy="65088"/>
                </a:xfrm>
                <a:custGeom>
                  <a:avLst/>
                  <a:gdLst>
                    <a:gd name="T0" fmla="*/ 25 w 50"/>
                    <a:gd name="T1" fmla="*/ 0 h 41"/>
                    <a:gd name="T2" fmla="*/ 50 w 50"/>
                    <a:gd name="T3" fmla="*/ 41 h 41"/>
                    <a:gd name="T4" fmla="*/ 0 w 50"/>
                    <a:gd name="T5" fmla="*/ 41 h 41"/>
                    <a:gd name="T6" fmla="*/ 25 w 50"/>
                    <a:gd name="T7" fmla="*/ 0 h 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0" h="41">
                      <a:moveTo>
                        <a:pt x="25" y="0"/>
                      </a:moveTo>
                      <a:lnTo>
                        <a:pt x="50" y="41"/>
                      </a:lnTo>
                      <a:lnTo>
                        <a:pt x="0" y="41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53" name="Line 89"/>
                <p:cNvSpPr>
                  <a:spLocks noChangeShapeType="1"/>
                </p:cNvSpPr>
                <p:nvPr/>
              </p:nvSpPr>
              <p:spPr bwMode="auto">
                <a:xfrm>
                  <a:off x="1216025" y="5743575"/>
                  <a:ext cx="2725738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54" name="Line 90"/>
                <p:cNvSpPr>
                  <a:spLocks noChangeShapeType="1"/>
                </p:cNvSpPr>
                <p:nvPr/>
              </p:nvSpPr>
              <p:spPr bwMode="auto">
                <a:xfrm>
                  <a:off x="1216025" y="5743575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55" name="Line 91"/>
                <p:cNvSpPr>
                  <a:spLocks noChangeShapeType="1"/>
                </p:cNvSpPr>
                <p:nvPr/>
              </p:nvSpPr>
              <p:spPr bwMode="auto">
                <a:xfrm>
                  <a:off x="2390775" y="5743575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56" name="Line 92"/>
                <p:cNvSpPr>
                  <a:spLocks noChangeShapeType="1"/>
                </p:cNvSpPr>
                <p:nvPr/>
              </p:nvSpPr>
              <p:spPr bwMode="auto">
                <a:xfrm>
                  <a:off x="3076575" y="5743575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57" name="Line 93"/>
                <p:cNvSpPr>
                  <a:spLocks noChangeShapeType="1"/>
                </p:cNvSpPr>
                <p:nvPr/>
              </p:nvSpPr>
              <p:spPr bwMode="auto">
                <a:xfrm>
                  <a:off x="3563938" y="5743575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58" name="Line 94"/>
                <p:cNvSpPr>
                  <a:spLocks noChangeShapeType="1"/>
                </p:cNvSpPr>
                <p:nvPr/>
              </p:nvSpPr>
              <p:spPr bwMode="auto">
                <a:xfrm>
                  <a:off x="3941763" y="5743575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59" name="Rectangle 95"/>
                <p:cNvSpPr>
                  <a:spLocks noChangeArrowheads="1"/>
                </p:cNvSpPr>
                <p:nvPr/>
              </p:nvSpPr>
              <p:spPr bwMode="auto">
                <a:xfrm>
                  <a:off x="1042988" y="5913438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0" name="Rectangle 96"/>
                <p:cNvSpPr>
                  <a:spLocks noChangeArrowheads="1"/>
                </p:cNvSpPr>
                <p:nvPr/>
              </p:nvSpPr>
              <p:spPr bwMode="auto">
                <a:xfrm>
                  <a:off x="2217738" y="5913438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1" name="Rectangle 97"/>
                <p:cNvSpPr>
                  <a:spLocks noChangeArrowheads="1"/>
                </p:cNvSpPr>
                <p:nvPr/>
              </p:nvSpPr>
              <p:spPr bwMode="auto">
                <a:xfrm>
                  <a:off x="2903538" y="5913438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2" name="Rectangle 98"/>
                <p:cNvSpPr>
                  <a:spLocks noChangeArrowheads="1"/>
                </p:cNvSpPr>
                <p:nvPr/>
              </p:nvSpPr>
              <p:spPr bwMode="auto">
                <a:xfrm>
                  <a:off x="3390900" y="5913438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3" name="Line 99"/>
                <p:cNvSpPr>
                  <a:spLocks noChangeShapeType="1"/>
                </p:cNvSpPr>
                <p:nvPr/>
              </p:nvSpPr>
              <p:spPr bwMode="auto">
                <a:xfrm flipV="1">
                  <a:off x="798513" y="3667125"/>
                  <a:ext cx="0" cy="200025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4" name="Line 100"/>
                <p:cNvSpPr>
                  <a:spLocks noChangeShapeType="1"/>
                </p:cNvSpPr>
                <p:nvPr/>
              </p:nvSpPr>
              <p:spPr bwMode="auto">
                <a:xfrm flipH="1">
                  <a:off x="719138" y="5667375"/>
                  <a:ext cx="793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5" name="Line 101"/>
                <p:cNvSpPr>
                  <a:spLocks noChangeShapeType="1"/>
                </p:cNvSpPr>
                <p:nvPr/>
              </p:nvSpPr>
              <p:spPr bwMode="auto">
                <a:xfrm flipH="1">
                  <a:off x="719138" y="5165725"/>
                  <a:ext cx="793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6" name="Line 102"/>
                <p:cNvSpPr>
                  <a:spLocks noChangeShapeType="1"/>
                </p:cNvSpPr>
                <p:nvPr/>
              </p:nvSpPr>
              <p:spPr bwMode="auto">
                <a:xfrm flipH="1">
                  <a:off x="719138" y="4672013"/>
                  <a:ext cx="793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7" name="Line 103"/>
                <p:cNvSpPr>
                  <a:spLocks noChangeShapeType="1"/>
                </p:cNvSpPr>
                <p:nvPr/>
              </p:nvSpPr>
              <p:spPr bwMode="auto">
                <a:xfrm flipH="1">
                  <a:off x="719138" y="4170363"/>
                  <a:ext cx="793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8" name="Line 104"/>
                <p:cNvSpPr>
                  <a:spLocks noChangeShapeType="1"/>
                </p:cNvSpPr>
                <p:nvPr/>
              </p:nvSpPr>
              <p:spPr bwMode="auto">
                <a:xfrm flipH="1">
                  <a:off x="719138" y="3667125"/>
                  <a:ext cx="793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9" name="Rectangle 105"/>
                <p:cNvSpPr>
                  <a:spLocks noChangeArrowheads="1"/>
                </p:cNvSpPr>
                <p:nvPr/>
              </p:nvSpPr>
              <p:spPr bwMode="auto">
                <a:xfrm rot="16200000">
                  <a:off x="482362" y="5575042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0" name="Rectangle 106"/>
                <p:cNvSpPr>
                  <a:spLocks noChangeArrowheads="1"/>
                </p:cNvSpPr>
                <p:nvPr/>
              </p:nvSpPr>
              <p:spPr bwMode="auto">
                <a:xfrm rot="16200000">
                  <a:off x="482362" y="5073392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1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1" name="Rectangle 107"/>
                <p:cNvSpPr>
                  <a:spLocks noChangeArrowheads="1"/>
                </p:cNvSpPr>
                <p:nvPr/>
              </p:nvSpPr>
              <p:spPr bwMode="auto">
                <a:xfrm rot="16200000">
                  <a:off x="482362" y="4579680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2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2" name="Rectangle 108"/>
                <p:cNvSpPr>
                  <a:spLocks noChangeArrowheads="1"/>
                </p:cNvSpPr>
                <p:nvPr/>
              </p:nvSpPr>
              <p:spPr bwMode="auto">
                <a:xfrm rot="16200000">
                  <a:off x="482362" y="4078030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3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3" name="Rectangle 109"/>
                <p:cNvSpPr>
                  <a:spLocks noChangeArrowheads="1"/>
                </p:cNvSpPr>
                <p:nvPr/>
              </p:nvSpPr>
              <p:spPr bwMode="auto">
                <a:xfrm rot="16200000">
                  <a:off x="482362" y="3574792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4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4" name="Rectangle 110"/>
                <p:cNvSpPr>
                  <a:spLocks noChangeArrowheads="1"/>
                </p:cNvSpPr>
                <p:nvPr/>
              </p:nvSpPr>
              <p:spPr bwMode="auto">
                <a:xfrm>
                  <a:off x="798513" y="3590925"/>
                  <a:ext cx="3402013" cy="2152650"/>
                </a:xfrm>
                <a:prstGeom prst="rect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5" name="Freeform 113"/>
                <p:cNvSpPr>
                  <a:spLocks/>
                </p:cNvSpPr>
                <p:nvPr/>
              </p:nvSpPr>
              <p:spPr bwMode="auto">
                <a:xfrm>
                  <a:off x="877888" y="5487988"/>
                  <a:ext cx="90488" cy="76200"/>
                </a:xfrm>
                <a:custGeom>
                  <a:avLst/>
                  <a:gdLst>
                    <a:gd name="T0" fmla="*/ 32 w 57"/>
                    <a:gd name="T1" fmla="*/ 0 h 48"/>
                    <a:gd name="T2" fmla="*/ 57 w 57"/>
                    <a:gd name="T3" fmla="*/ 48 h 48"/>
                    <a:gd name="T4" fmla="*/ 0 w 57"/>
                    <a:gd name="T5" fmla="*/ 48 h 48"/>
                    <a:gd name="T6" fmla="*/ 32 w 57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7" h="48">
                      <a:moveTo>
                        <a:pt x="32" y="0"/>
                      </a:moveTo>
                      <a:lnTo>
                        <a:pt x="57" y="48"/>
                      </a:lnTo>
                      <a:lnTo>
                        <a:pt x="0" y="48"/>
                      </a:lnTo>
                      <a:lnTo>
                        <a:pt x="32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6" name="Freeform 114"/>
                <p:cNvSpPr>
                  <a:spLocks/>
                </p:cNvSpPr>
                <p:nvPr/>
              </p:nvSpPr>
              <p:spPr bwMode="auto">
                <a:xfrm>
                  <a:off x="2649538" y="5345113"/>
                  <a:ext cx="98425" cy="76200"/>
                </a:xfrm>
                <a:custGeom>
                  <a:avLst/>
                  <a:gdLst>
                    <a:gd name="T0" fmla="*/ 31 w 62"/>
                    <a:gd name="T1" fmla="*/ 0 h 48"/>
                    <a:gd name="T2" fmla="*/ 62 w 62"/>
                    <a:gd name="T3" fmla="*/ 48 h 48"/>
                    <a:gd name="T4" fmla="*/ 0 w 62"/>
                    <a:gd name="T5" fmla="*/ 48 h 48"/>
                    <a:gd name="T6" fmla="*/ 31 w 62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2" h="48">
                      <a:moveTo>
                        <a:pt x="31" y="0"/>
                      </a:moveTo>
                      <a:lnTo>
                        <a:pt x="62" y="48"/>
                      </a:lnTo>
                      <a:lnTo>
                        <a:pt x="0" y="48"/>
                      </a:lnTo>
                      <a:lnTo>
                        <a:pt x="31" y="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7" name="Freeform 115"/>
                <p:cNvSpPr>
                  <a:spLocks/>
                </p:cNvSpPr>
                <p:nvPr/>
              </p:nvSpPr>
              <p:spPr bwMode="auto">
                <a:xfrm>
                  <a:off x="4032250" y="5251450"/>
                  <a:ext cx="88900" cy="74613"/>
                </a:xfrm>
                <a:custGeom>
                  <a:avLst/>
                  <a:gdLst>
                    <a:gd name="T0" fmla="*/ 25 w 56"/>
                    <a:gd name="T1" fmla="*/ 0 h 47"/>
                    <a:gd name="T2" fmla="*/ 56 w 56"/>
                    <a:gd name="T3" fmla="*/ 47 h 47"/>
                    <a:gd name="T4" fmla="*/ 0 w 56"/>
                    <a:gd name="T5" fmla="*/ 47 h 47"/>
                    <a:gd name="T6" fmla="*/ 25 w 56"/>
                    <a:gd name="T7" fmla="*/ 0 h 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6" h="47">
                      <a:moveTo>
                        <a:pt x="25" y="0"/>
                      </a:moveTo>
                      <a:lnTo>
                        <a:pt x="56" y="47"/>
                      </a:lnTo>
                      <a:lnTo>
                        <a:pt x="0" y="47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8" name="Freeform 117"/>
                <p:cNvSpPr>
                  <a:spLocks/>
                </p:cNvSpPr>
                <p:nvPr/>
              </p:nvSpPr>
              <p:spPr bwMode="auto">
                <a:xfrm>
                  <a:off x="877888" y="5307013"/>
                  <a:ext cx="90488" cy="85725"/>
                </a:xfrm>
                <a:custGeom>
                  <a:avLst/>
                  <a:gdLst>
                    <a:gd name="T0" fmla="*/ 5 w 9"/>
                    <a:gd name="T1" fmla="*/ 9 h 9"/>
                    <a:gd name="T2" fmla="*/ 9 w 9"/>
                    <a:gd name="T3" fmla="*/ 0 h 9"/>
                    <a:gd name="T4" fmla="*/ 0 w 9"/>
                    <a:gd name="T5" fmla="*/ 0 h 9"/>
                    <a:gd name="T6" fmla="*/ 5 w 9"/>
                    <a:gd name="T7" fmla="*/ 9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9" h="9">
                      <a:moveTo>
                        <a:pt x="5" y="9"/>
                      </a:moveTo>
                      <a:lnTo>
                        <a:pt x="9" y="0"/>
                      </a:lnTo>
                      <a:lnTo>
                        <a:pt x="0" y="0"/>
                      </a:lnTo>
                      <a:lnTo>
                        <a:pt x="5" y="9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9" name="Freeform 118"/>
                <p:cNvSpPr>
                  <a:spLocks/>
                </p:cNvSpPr>
                <p:nvPr/>
              </p:nvSpPr>
              <p:spPr bwMode="auto">
                <a:xfrm>
                  <a:off x="2649538" y="5251450"/>
                  <a:ext cx="98425" cy="84138"/>
                </a:xfrm>
                <a:custGeom>
                  <a:avLst/>
                  <a:gdLst>
                    <a:gd name="T0" fmla="*/ 5 w 10"/>
                    <a:gd name="T1" fmla="*/ 9 h 9"/>
                    <a:gd name="T2" fmla="*/ 10 w 10"/>
                    <a:gd name="T3" fmla="*/ 0 h 9"/>
                    <a:gd name="T4" fmla="*/ 0 w 10"/>
                    <a:gd name="T5" fmla="*/ 0 h 9"/>
                    <a:gd name="T6" fmla="*/ 5 w 10"/>
                    <a:gd name="T7" fmla="*/ 9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9">
                      <a:moveTo>
                        <a:pt x="5" y="9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9"/>
                      </a:lnTo>
                    </a:path>
                  </a:pathLst>
                </a:custGeom>
                <a:noFill/>
                <a:ln w="6" cap="rnd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0" name="Freeform 119"/>
                <p:cNvSpPr>
                  <a:spLocks/>
                </p:cNvSpPr>
                <p:nvPr/>
              </p:nvSpPr>
              <p:spPr bwMode="auto">
                <a:xfrm>
                  <a:off x="4032250" y="5222875"/>
                  <a:ext cx="88900" cy="74613"/>
                </a:xfrm>
                <a:custGeom>
                  <a:avLst/>
                  <a:gdLst>
                    <a:gd name="T0" fmla="*/ 4 w 9"/>
                    <a:gd name="T1" fmla="*/ 8 h 8"/>
                    <a:gd name="T2" fmla="*/ 9 w 9"/>
                    <a:gd name="T3" fmla="*/ 0 h 8"/>
                    <a:gd name="T4" fmla="*/ 0 w 9"/>
                    <a:gd name="T5" fmla="*/ 0 h 8"/>
                    <a:gd name="T6" fmla="*/ 4 w 9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9" h="8">
                      <a:moveTo>
                        <a:pt x="4" y="8"/>
                      </a:moveTo>
                      <a:lnTo>
                        <a:pt x="9" y="0"/>
                      </a:lnTo>
                      <a:lnTo>
                        <a:pt x="0" y="0"/>
                      </a:lnTo>
                      <a:lnTo>
                        <a:pt x="4" y="8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1" name="Freeform 121"/>
                <p:cNvSpPr>
                  <a:spLocks noEditPoints="1"/>
                </p:cNvSpPr>
                <p:nvPr/>
              </p:nvSpPr>
              <p:spPr bwMode="auto">
                <a:xfrm>
                  <a:off x="809625" y="5487988"/>
                  <a:ext cx="3390900" cy="0"/>
                </a:xfrm>
                <a:custGeom>
                  <a:avLst/>
                  <a:gdLst>
                    <a:gd name="T0" fmla="*/ 4 w 341"/>
                    <a:gd name="T1" fmla="*/ 11 w 341"/>
                    <a:gd name="T2" fmla="*/ 16 w 341"/>
                    <a:gd name="T3" fmla="*/ 23 w 341"/>
                    <a:gd name="T4" fmla="*/ 28 w 341"/>
                    <a:gd name="T5" fmla="*/ 35 w 341"/>
                    <a:gd name="T6" fmla="*/ 40 w 341"/>
                    <a:gd name="T7" fmla="*/ 47 w 341"/>
                    <a:gd name="T8" fmla="*/ 52 w 341"/>
                    <a:gd name="T9" fmla="*/ 59 w 341"/>
                    <a:gd name="T10" fmla="*/ 64 w 341"/>
                    <a:gd name="T11" fmla="*/ 71 w 341"/>
                    <a:gd name="T12" fmla="*/ 76 w 341"/>
                    <a:gd name="T13" fmla="*/ 83 w 341"/>
                    <a:gd name="T14" fmla="*/ 88 w 341"/>
                    <a:gd name="T15" fmla="*/ 95 w 341"/>
                    <a:gd name="T16" fmla="*/ 100 w 341"/>
                    <a:gd name="T17" fmla="*/ 107 w 341"/>
                    <a:gd name="T18" fmla="*/ 112 w 341"/>
                    <a:gd name="T19" fmla="*/ 119 w 341"/>
                    <a:gd name="T20" fmla="*/ 124 w 341"/>
                    <a:gd name="T21" fmla="*/ 131 w 341"/>
                    <a:gd name="T22" fmla="*/ 136 w 341"/>
                    <a:gd name="T23" fmla="*/ 143 w 341"/>
                    <a:gd name="T24" fmla="*/ 148 w 341"/>
                    <a:gd name="T25" fmla="*/ 155 w 341"/>
                    <a:gd name="T26" fmla="*/ 160 w 341"/>
                    <a:gd name="T27" fmla="*/ 167 w 341"/>
                    <a:gd name="T28" fmla="*/ 172 w 341"/>
                    <a:gd name="T29" fmla="*/ 179 w 341"/>
                    <a:gd name="T30" fmla="*/ 184 w 341"/>
                    <a:gd name="T31" fmla="*/ 191 w 341"/>
                    <a:gd name="T32" fmla="*/ 196 w 341"/>
                    <a:gd name="T33" fmla="*/ 203 w 341"/>
                    <a:gd name="T34" fmla="*/ 208 w 341"/>
                    <a:gd name="T35" fmla="*/ 215 w 341"/>
                    <a:gd name="T36" fmla="*/ 220 w 341"/>
                    <a:gd name="T37" fmla="*/ 227 w 341"/>
                    <a:gd name="T38" fmla="*/ 232 w 341"/>
                    <a:gd name="T39" fmla="*/ 239 w 341"/>
                    <a:gd name="T40" fmla="*/ 244 w 341"/>
                    <a:gd name="T41" fmla="*/ 251 w 341"/>
                    <a:gd name="T42" fmla="*/ 256 w 341"/>
                    <a:gd name="T43" fmla="*/ 263 w 341"/>
                    <a:gd name="T44" fmla="*/ 268 w 341"/>
                    <a:gd name="T45" fmla="*/ 275 w 341"/>
                    <a:gd name="T46" fmla="*/ 280 w 341"/>
                    <a:gd name="T47" fmla="*/ 287 w 341"/>
                    <a:gd name="T48" fmla="*/ 292 w 341"/>
                    <a:gd name="T49" fmla="*/ 299 w 341"/>
                    <a:gd name="T50" fmla="*/ 304 w 341"/>
                    <a:gd name="T51" fmla="*/ 311 w 341"/>
                    <a:gd name="T52" fmla="*/ 316 w 341"/>
                    <a:gd name="T53" fmla="*/ 323 w 341"/>
                    <a:gd name="T54" fmla="*/ 328 w 341"/>
                    <a:gd name="T55" fmla="*/ 335 w 341"/>
                    <a:gd name="T56" fmla="*/ 340 w 341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</a:cxnLst>
                  <a:rect l="0" t="0" r="r" b="b"/>
                  <a:pathLst>
                    <a:path w="341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2" name="Freeform 122"/>
                <p:cNvSpPr>
                  <a:spLocks noEditPoints="1"/>
                </p:cNvSpPr>
                <p:nvPr/>
              </p:nvSpPr>
              <p:spPr bwMode="auto">
                <a:xfrm>
                  <a:off x="809625" y="5345113"/>
                  <a:ext cx="3390900" cy="0"/>
                </a:xfrm>
                <a:custGeom>
                  <a:avLst/>
                  <a:gdLst>
                    <a:gd name="T0" fmla="*/ 4 w 341"/>
                    <a:gd name="T1" fmla="*/ 11 w 341"/>
                    <a:gd name="T2" fmla="*/ 16 w 341"/>
                    <a:gd name="T3" fmla="*/ 23 w 341"/>
                    <a:gd name="T4" fmla="*/ 28 w 341"/>
                    <a:gd name="T5" fmla="*/ 35 w 341"/>
                    <a:gd name="T6" fmla="*/ 40 w 341"/>
                    <a:gd name="T7" fmla="*/ 47 w 341"/>
                    <a:gd name="T8" fmla="*/ 52 w 341"/>
                    <a:gd name="T9" fmla="*/ 59 w 341"/>
                    <a:gd name="T10" fmla="*/ 64 w 341"/>
                    <a:gd name="T11" fmla="*/ 71 w 341"/>
                    <a:gd name="T12" fmla="*/ 76 w 341"/>
                    <a:gd name="T13" fmla="*/ 83 w 341"/>
                    <a:gd name="T14" fmla="*/ 88 w 341"/>
                    <a:gd name="T15" fmla="*/ 95 w 341"/>
                    <a:gd name="T16" fmla="*/ 100 w 341"/>
                    <a:gd name="T17" fmla="*/ 107 w 341"/>
                    <a:gd name="T18" fmla="*/ 112 w 341"/>
                    <a:gd name="T19" fmla="*/ 119 w 341"/>
                    <a:gd name="T20" fmla="*/ 124 w 341"/>
                    <a:gd name="T21" fmla="*/ 131 w 341"/>
                    <a:gd name="T22" fmla="*/ 136 w 341"/>
                    <a:gd name="T23" fmla="*/ 143 w 341"/>
                    <a:gd name="T24" fmla="*/ 148 w 341"/>
                    <a:gd name="T25" fmla="*/ 155 w 341"/>
                    <a:gd name="T26" fmla="*/ 160 w 341"/>
                    <a:gd name="T27" fmla="*/ 167 w 341"/>
                    <a:gd name="T28" fmla="*/ 172 w 341"/>
                    <a:gd name="T29" fmla="*/ 179 w 341"/>
                    <a:gd name="T30" fmla="*/ 184 w 341"/>
                    <a:gd name="T31" fmla="*/ 191 w 341"/>
                    <a:gd name="T32" fmla="*/ 196 w 341"/>
                    <a:gd name="T33" fmla="*/ 203 w 341"/>
                    <a:gd name="T34" fmla="*/ 208 w 341"/>
                    <a:gd name="T35" fmla="*/ 215 w 341"/>
                    <a:gd name="T36" fmla="*/ 220 w 341"/>
                    <a:gd name="T37" fmla="*/ 227 w 341"/>
                    <a:gd name="T38" fmla="*/ 232 w 341"/>
                    <a:gd name="T39" fmla="*/ 239 w 341"/>
                    <a:gd name="T40" fmla="*/ 244 w 341"/>
                    <a:gd name="T41" fmla="*/ 251 w 341"/>
                    <a:gd name="T42" fmla="*/ 256 w 341"/>
                    <a:gd name="T43" fmla="*/ 263 w 341"/>
                    <a:gd name="T44" fmla="*/ 268 w 341"/>
                    <a:gd name="T45" fmla="*/ 275 w 341"/>
                    <a:gd name="T46" fmla="*/ 280 w 341"/>
                    <a:gd name="T47" fmla="*/ 287 w 341"/>
                    <a:gd name="T48" fmla="*/ 292 w 341"/>
                    <a:gd name="T49" fmla="*/ 299 w 341"/>
                    <a:gd name="T50" fmla="*/ 304 w 341"/>
                    <a:gd name="T51" fmla="*/ 311 w 341"/>
                    <a:gd name="T52" fmla="*/ 316 w 341"/>
                    <a:gd name="T53" fmla="*/ 323 w 341"/>
                    <a:gd name="T54" fmla="*/ 328 w 341"/>
                    <a:gd name="T55" fmla="*/ 335 w 341"/>
                    <a:gd name="T56" fmla="*/ 340 w 341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</a:cxnLst>
                  <a:rect l="0" t="0" r="r" b="b"/>
                  <a:pathLst>
                    <a:path w="341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grpSp>
            <p:nvGrpSpPr>
              <p:cNvPr id="16" name="Group 15"/>
              <p:cNvGrpSpPr/>
              <p:nvPr/>
            </p:nvGrpSpPr>
            <p:grpSpPr>
              <a:xfrm>
                <a:off x="4999039" y="3665068"/>
                <a:ext cx="3858170" cy="2354616"/>
                <a:chOff x="4886067" y="3558938"/>
                <a:chExt cx="3700721" cy="2539166"/>
              </a:xfrm>
            </p:grpSpPr>
            <p:sp>
              <p:nvSpPr>
                <p:cNvPr id="17" name="Freeform 123"/>
                <p:cNvSpPr>
                  <a:spLocks/>
                </p:cNvSpPr>
                <p:nvPr/>
              </p:nvSpPr>
              <p:spPr bwMode="auto">
                <a:xfrm>
                  <a:off x="5265738" y="5526088"/>
                  <a:ext cx="88900" cy="66675"/>
                </a:xfrm>
                <a:custGeom>
                  <a:avLst/>
                  <a:gdLst>
                    <a:gd name="T0" fmla="*/ 31 w 56"/>
                    <a:gd name="T1" fmla="*/ 0 h 42"/>
                    <a:gd name="T2" fmla="*/ 56 w 56"/>
                    <a:gd name="T3" fmla="*/ 42 h 42"/>
                    <a:gd name="T4" fmla="*/ 0 w 56"/>
                    <a:gd name="T5" fmla="*/ 42 h 42"/>
                    <a:gd name="T6" fmla="*/ 31 w 56"/>
                    <a:gd name="T7" fmla="*/ 0 h 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6" h="42">
                      <a:moveTo>
                        <a:pt x="31" y="0"/>
                      </a:moveTo>
                      <a:lnTo>
                        <a:pt x="56" y="42"/>
                      </a:lnTo>
                      <a:lnTo>
                        <a:pt x="0" y="42"/>
                      </a:lnTo>
                      <a:lnTo>
                        <a:pt x="31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" name="Freeform 124"/>
                <p:cNvSpPr>
                  <a:spLocks/>
                </p:cNvSpPr>
                <p:nvPr/>
              </p:nvSpPr>
              <p:spPr bwMode="auto">
                <a:xfrm>
                  <a:off x="7045325" y="5487988"/>
                  <a:ext cx="79375" cy="66675"/>
                </a:xfrm>
                <a:custGeom>
                  <a:avLst/>
                  <a:gdLst>
                    <a:gd name="T0" fmla="*/ 25 w 50"/>
                    <a:gd name="T1" fmla="*/ 0 h 42"/>
                    <a:gd name="T2" fmla="*/ 50 w 50"/>
                    <a:gd name="T3" fmla="*/ 42 h 42"/>
                    <a:gd name="T4" fmla="*/ 0 w 50"/>
                    <a:gd name="T5" fmla="*/ 42 h 42"/>
                    <a:gd name="T6" fmla="*/ 25 w 50"/>
                    <a:gd name="T7" fmla="*/ 0 h 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0" h="42">
                      <a:moveTo>
                        <a:pt x="25" y="0"/>
                      </a:moveTo>
                      <a:lnTo>
                        <a:pt x="50" y="42"/>
                      </a:lnTo>
                      <a:lnTo>
                        <a:pt x="0" y="42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" name="Freeform 125"/>
                <p:cNvSpPr>
                  <a:spLocks/>
                </p:cNvSpPr>
                <p:nvPr/>
              </p:nvSpPr>
              <p:spPr bwMode="auto">
                <a:xfrm>
                  <a:off x="8418513" y="5430838"/>
                  <a:ext cx="79375" cy="66675"/>
                </a:xfrm>
                <a:custGeom>
                  <a:avLst/>
                  <a:gdLst>
                    <a:gd name="T0" fmla="*/ 25 w 50"/>
                    <a:gd name="T1" fmla="*/ 0 h 42"/>
                    <a:gd name="T2" fmla="*/ 50 w 50"/>
                    <a:gd name="T3" fmla="*/ 42 h 42"/>
                    <a:gd name="T4" fmla="*/ 0 w 50"/>
                    <a:gd name="T5" fmla="*/ 42 h 42"/>
                    <a:gd name="T6" fmla="*/ 25 w 50"/>
                    <a:gd name="T7" fmla="*/ 0 h 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0" h="42">
                      <a:moveTo>
                        <a:pt x="25" y="0"/>
                      </a:moveTo>
                      <a:lnTo>
                        <a:pt x="50" y="42"/>
                      </a:lnTo>
                      <a:lnTo>
                        <a:pt x="0" y="42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" name="Line 126"/>
                <p:cNvSpPr>
                  <a:spLocks noChangeShapeType="1"/>
                </p:cNvSpPr>
                <p:nvPr/>
              </p:nvSpPr>
              <p:spPr bwMode="auto">
                <a:xfrm>
                  <a:off x="5603875" y="5743575"/>
                  <a:ext cx="272415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" name="Line 127"/>
                <p:cNvSpPr>
                  <a:spLocks noChangeShapeType="1"/>
                </p:cNvSpPr>
                <p:nvPr/>
              </p:nvSpPr>
              <p:spPr bwMode="auto">
                <a:xfrm>
                  <a:off x="5603875" y="5743575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2" name="Line 128"/>
                <p:cNvSpPr>
                  <a:spLocks noChangeShapeType="1"/>
                </p:cNvSpPr>
                <p:nvPr/>
              </p:nvSpPr>
              <p:spPr bwMode="auto">
                <a:xfrm>
                  <a:off x="6777038" y="5743575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3" name="Line 129"/>
                <p:cNvSpPr>
                  <a:spLocks noChangeShapeType="1"/>
                </p:cNvSpPr>
                <p:nvPr/>
              </p:nvSpPr>
              <p:spPr bwMode="auto">
                <a:xfrm>
                  <a:off x="7462838" y="5743575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4" name="Line 130"/>
                <p:cNvSpPr>
                  <a:spLocks noChangeShapeType="1"/>
                </p:cNvSpPr>
                <p:nvPr/>
              </p:nvSpPr>
              <p:spPr bwMode="auto">
                <a:xfrm>
                  <a:off x="7950200" y="5743575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5" name="Line 131"/>
                <p:cNvSpPr>
                  <a:spLocks noChangeShapeType="1"/>
                </p:cNvSpPr>
                <p:nvPr/>
              </p:nvSpPr>
              <p:spPr bwMode="auto">
                <a:xfrm>
                  <a:off x="8328025" y="5743575"/>
                  <a:ext cx="0" cy="7620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6" name="Rectangle 132"/>
                <p:cNvSpPr>
                  <a:spLocks noChangeArrowheads="1"/>
                </p:cNvSpPr>
                <p:nvPr/>
              </p:nvSpPr>
              <p:spPr bwMode="auto">
                <a:xfrm>
                  <a:off x="5430838" y="5913438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7" name="Rectangle 133"/>
                <p:cNvSpPr>
                  <a:spLocks noChangeArrowheads="1"/>
                </p:cNvSpPr>
                <p:nvPr/>
              </p:nvSpPr>
              <p:spPr bwMode="auto">
                <a:xfrm>
                  <a:off x="6604000" y="5913438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" name="Rectangle 134"/>
                <p:cNvSpPr>
                  <a:spLocks noChangeArrowheads="1"/>
                </p:cNvSpPr>
                <p:nvPr/>
              </p:nvSpPr>
              <p:spPr bwMode="auto">
                <a:xfrm>
                  <a:off x="7289800" y="5913438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" name="Rectangle 135"/>
                <p:cNvSpPr>
                  <a:spLocks noChangeArrowheads="1"/>
                </p:cNvSpPr>
                <p:nvPr/>
              </p:nvSpPr>
              <p:spPr bwMode="auto">
                <a:xfrm>
                  <a:off x="7777163" y="5913438"/>
                  <a:ext cx="33983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" name="Line 136"/>
                <p:cNvSpPr>
                  <a:spLocks noChangeShapeType="1"/>
                </p:cNvSpPr>
                <p:nvPr/>
              </p:nvSpPr>
              <p:spPr bwMode="auto">
                <a:xfrm flipV="1">
                  <a:off x="5184775" y="3667125"/>
                  <a:ext cx="0" cy="200025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31" name="Line 137"/>
                <p:cNvSpPr>
                  <a:spLocks noChangeShapeType="1"/>
                </p:cNvSpPr>
                <p:nvPr/>
              </p:nvSpPr>
              <p:spPr bwMode="auto">
                <a:xfrm flipH="1">
                  <a:off x="5105400" y="5667375"/>
                  <a:ext cx="793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32" name="Line 138"/>
                <p:cNvSpPr>
                  <a:spLocks noChangeShapeType="1"/>
                </p:cNvSpPr>
                <p:nvPr/>
              </p:nvSpPr>
              <p:spPr bwMode="auto">
                <a:xfrm flipH="1">
                  <a:off x="5105400" y="5165725"/>
                  <a:ext cx="793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33" name="Line 139"/>
                <p:cNvSpPr>
                  <a:spLocks noChangeShapeType="1"/>
                </p:cNvSpPr>
                <p:nvPr/>
              </p:nvSpPr>
              <p:spPr bwMode="auto">
                <a:xfrm flipH="1">
                  <a:off x="5105400" y="4672013"/>
                  <a:ext cx="793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34" name="Line 140"/>
                <p:cNvSpPr>
                  <a:spLocks noChangeShapeType="1"/>
                </p:cNvSpPr>
                <p:nvPr/>
              </p:nvSpPr>
              <p:spPr bwMode="auto">
                <a:xfrm flipH="1">
                  <a:off x="5105400" y="4170363"/>
                  <a:ext cx="793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35" name="Line 141"/>
                <p:cNvSpPr>
                  <a:spLocks noChangeShapeType="1"/>
                </p:cNvSpPr>
                <p:nvPr/>
              </p:nvSpPr>
              <p:spPr bwMode="auto">
                <a:xfrm flipH="1">
                  <a:off x="5105400" y="3667125"/>
                  <a:ext cx="793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36" name="Rectangle 142"/>
                <p:cNvSpPr>
                  <a:spLocks noChangeArrowheads="1"/>
                </p:cNvSpPr>
                <p:nvPr/>
              </p:nvSpPr>
              <p:spPr bwMode="auto">
                <a:xfrm rot="16200000">
                  <a:off x="4871800" y="5573455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" name="Rectangle 143"/>
                <p:cNvSpPr>
                  <a:spLocks noChangeArrowheads="1"/>
                </p:cNvSpPr>
                <p:nvPr/>
              </p:nvSpPr>
              <p:spPr bwMode="auto">
                <a:xfrm rot="16200000">
                  <a:off x="4871800" y="5071805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1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" name="Rectangle 144"/>
                <p:cNvSpPr>
                  <a:spLocks noChangeArrowheads="1"/>
                </p:cNvSpPr>
                <p:nvPr/>
              </p:nvSpPr>
              <p:spPr bwMode="auto">
                <a:xfrm rot="16200000">
                  <a:off x="4871800" y="4578092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2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9" name="Rectangle 145"/>
                <p:cNvSpPr>
                  <a:spLocks noChangeArrowheads="1"/>
                </p:cNvSpPr>
                <p:nvPr/>
              </p:nvSpPr>
              <p:spPr bwMode="auto">
                <a:xfrm rot="16200000">
                  <a:off x="4871800" y="4076442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3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" name="Rectangle 146"/>
                <p:cNvSpPr>
                  <a:spLocks noChangeArrowheads="1"/>
                </p:cNvSpPr>
                <p:nvPr/>
              </p:nvSpPr>
              <p:spPr bwMode="auto">
                <a:xfrm rot="16200000">
                  <a:off x="4871800" y="3573205"/>
                  <a:ext cx="21320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4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1" name="Rectangle 147"/>
                <p:cNvSpPr>
                  <a:spLocks noChangeArrowheads="1"/>
                </p:cNvSpPr>
                <p:nvPr/>
              </p:nvSpPr>
              <p:spPr bwMode="auto">
                <a:xfrm>
                  <a:off x="5184775" y="3590925"/>
                  <a:ext cx="3402013" cy="2152650"/>
                </a:xfrm>
                <a:prstGeom prst="rect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42" name="Freeform 150"/>
                <p:cNvSpPr>
                  <a:spLocks/>
                </p:cNvSpPr>
                <p:nvPr/>
              </p:nvSpPr>
              <p:spPr bwMode="auto">
                <a:xfrm>
                  <a:off x="5265738" y="5516563"/>
                  <a:ext cx="88900" cy="76200"/>
                </a:xfrm>
                <a:custGeom>
                  <a:avLst/>
                  <a:gdLst>
                    <a:gd name="T0" fmla="*/ 31 w 56"/>
                    <a:gd name="T1" fmla="*/ 0 h 48"/>
                    <a:gd name="T2" fmla="*/ 56 w 56"/>
                    <a:gd name="T3" fmla="*/ 48 h 48"/>
                    <a:gd name="T4" fmla="*/ 0 w 56"/>
                    <a:gd name="T5" fmla="*/ 48 h 48"/>
                    <a:gd name="T6" fmla="*/ 31 w 56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6" h="48">
                      <a:moveTo>
                        <a:pt x="31" y="0"/>
                      </a:moveTo>
                      <a:lnTo>
                        <a:pt x="56" y="48"/>
                      </a:lnTo>
                      <a:lnTo>
                        <a:pt x="0" y="48"/>
                      </a:lnTo>
                      <a:lnTo>
                        <a:pt x="31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43" name="Freeform 151"/>
                <p:cNvSpPr>
                  <a:spLocks/>
                </p:cNvSpPr>
                <p:nvPr/>
              </p:nvSpPr>
              <p:spPr bwMode="auto">
                <a:xfrm>
                  <a:off x="7035800" y="5478463"/>
                  <a:ext cx="100013" cy="76200"/>
                </a:xfrm>
                <a:custGeom>
                  <a:avLst/>
                  <a:gdLst>
                    <a:gd name="T0" fmla="*/ 31 w 63"/>
                    <a:gd name="T1" fmla="*/ 0 h 48"/>
                    <a:gd name="T2" fmla="*/ 63 w 63"/>
                    <a:gd name="T3" fmla="*/ 48 h 48"/>
                    <a:gd name="T4" fmla="*/ 0 w 63"/>
                    <a:gd name="T5" fmla="*/ 48 h 48"/>
                    <a:gd name="T6" fmla="*/ 31 w 63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3" h="48">
                      <a:moveTo>
                        <a:pt x="31" y="0"/>
                      </a:moveTo>
                      <a:lnTo>
                        <a:pt x="63" y="48"/>
                      </a:lnTo>
                      <a:lnTo>
                        <a:pt x="0" y="48"/>
                      </a:lnTo>
                      <a:lnTo>
                        <a:pt x="31" y="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44" name="Freeform 152"/>
                <p:cNvSpPr>
                  <a:spLocks/>
                </p:cNvSpPr>
                <p:nvPr/>
              </p:nvSpPr>
              <p:spPr bwMode="auto">
                <a:xfrm>
                  <a:off x="8418513" y="5421313"/>
                  <a:ext cx="88900" cy="76200"/>
                </a:xfrm>
                <a:custGeom>
                  <a:avLst/>
                  <a:gdLst>
                    <a:gd name="T0" fmla="*/ 25 w 56"/>
                    <a:gd name="T1" fmla="*/ 0 h 48"/>
                    <a:gd name="T2" fmla="*/ 56 w 56"/>
                    <a:gd name="T3" fmla="*/ 48 h 48"/>
                    <a:gd name="T4" fmla="*/ 0 w 56"/>
                    <a:gd name="T5" fmla="*/ 48 h 48"/>
                    <a:gd name="T6" fmla="*/ 25 w 56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6" h="48">
                      <a:moveTo>
                        <a:pt x="25" y="0"/>
                      </a:moveTo>
                      <a:lnTo>
                        <a:pt x="56" y="48"/>
                      </a:lnTo>
                      <a:lnTo>
                        <a:pt x="0" y="48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45" name="Freeform 154"/>
                <p:cNvSpPr>
                  <a:spLocks/>
                </p:cNvSpPr>
                <p:nvPr/>
              </p:nvSpPr>
              <p:spPr bwMode="auto">
                <a:xfrm>
                  <a:off x="5265738" y="5307013"/>
                  <a:ext cx="88900" cy="76200"/>
                </a:xfrm>
                <a:custGeom>
                  <a:avLst/>
                  <a:gdLst>
                    <a:gd name="T0" fmla="*/ 5 w 9"/>
                    <a:gd name="T1" fmla="*/ 8 h 8"/>
                    <a:gd name="T2" fmla="*/ 9 w 9"/>
                    <a:gd name="T3" fmla="*/ 0 h 8"/>
                    <a:gd name="T4" fmla="*/ 0 w 9"/>
                    <a:gd name="T5" fmla="*/ 0 h 8"/>
                    <a:gd name="T6" fmla="*/ 5 w 9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9" h="8">
                      <a:moveTo>
                        <a:pt x="5" y="8"/>
                      </a:moveTo>
                      <a:lnTo>
                        <a:pt x="9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46" name="Freeform 155"/>
                <p:cNvSpPr>
                  <a:spLocks/>
                </p:cNvSpPr>
                <p:nvPr/>
              </p:nvSpPr>
              <p:spPr bwMode="auto">
                <a:xfrm>
                  <a:off x="7035800" y="5335588"/>
                  <a:ext cx="100013" cy="76200"/>
                </a:xfrm>
                <a:custGeom>
                  <a:avLst/>
                  <a:gdLst>
                    <a:gd name="T0" fmla="*/ 5 w 10"/>
                    <a:gd name="T1" fmla="*/ 8 h 8"/>
                    <a:gd name="T2" fmla="*/ 10 w 10"/>
                    <a:gd name="T3" fmla="*/ 0 h 8"/>
                    <a:gd name="T4" fmla="*/ 0 w 10"/>
                    <a:gd name="T5" fmla="*/ 0 h 8"/>
                    <a:gd name="T6" fmla="*/ 5 w 10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8">
                      <a:moveTo>
                        <a:pt x="5" y="8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47" name="Freeform 156"/>
                <p:cNvSpPr>
                  <a:spLocks/>
                </p:cNvSpPr>
                <p:nvPr/>
              </p:nvSpPr>
              <p:spPr bwMode="auto">
                <a:xfrm>
                  <a:off x="8418513" y="5232400"/>
                  <a:ext cx="88900" cy="74613"/>
                </a:xfrm>
                <a:custGeom>
                  <a:avLst/>
                  <a:gdLst>
                    <a:gd name="T0" fmla="*/ 4 w 9"/>
                    <a:gd name="T1" fmla="*/ 8 h 8"/>
                    <a:gd name="T2" fmla="*/ 9 w 9"/>
                    <a:gd name="T3" fmla="*/ 0 h 8"/>
                    <a:gd name="T4" fmla="*/ 0 w 9"/>
                    <a:gd name="T5" fmla="*/ 0 h 8"/>
                    <a:gd name="T6" fmla="*/ 4 w 9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9" h="8">
                      <a:moveTo>
                        <a:pt x="4" y="8"/>
                      </a:moveTo>
                      <a:lnTo>
                        <a:pt x="9" y="0"/>
                      </a:lnTo>
                      <a:lnTo>
                        <a:pt x="0" y="0"/>
                      </a:lnTo>
                      <a:lnTo>
                        <a:pt x="4" y="8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48" name="Freeform 158"/>
                <p:cNvSpPr>
                  <a:spLocks noEditPoints="1"/>
                </p:cNvSpPr>
                <p:nvPr/>
              </p:nvSpPr>
              <p:spPr bwMode="auto">
                <a:xfrm>
                  <a:off x="5195888" y="5487988"/>
                  <a:ext cx="3390900" cy="0"/>
                </a:xfrm>
                <a:custGeom>
                  <a:avLst/>
                  <a:gdLst>
                    <a:gd name="T0" fmla="*/ 4 w 341"/>
                    <a:gd name="T1" fmla="*/ 11 w 341"/>
                    <a:gd name="T2" fmla="*/ 16 w 341"/>
                    <a:gd name="T3" fmla="*/ 23 w 341"/>
                    <a:gd name="T4" fmla="*/ 28 w 341"/>
                    <a:gd name="T5" fmla="*/ 35 w 341"/>
                    <a:gd name="T6" fmla="*/ 40 w 341"/>
                    <a:gd name="T7" fmla="*/ 47 w 341"/>
                    <a:gd name="T8" fmla="*/ 52 w 341"/>
                    <a:gd name="T9" fmla="*/ 59 w 341"/>
                    <a:gd name="T10" fmla="*/ 64 w 341"/>
                    <a:gd name="T11" fmla="*/ 71 w 341"/>
                    <a:gd name="T12" fmla="*/ 76 w 341"/>
                    <a:gd name="T13" fmla="*/ 83 w 341"/>
                    <a:gd name="T14" fmla="*/ 88 w 341"/>
                    <a:gd name="T15" fmla="*/ 95 w 341"/>
                    <a:gd name="T16" fmla="*/ 100 w 341"/>
                    <a:gd name="T17" fmla="*/ 107 w 341"/>
                    <a:gd name="T18" fmla="*/ 112 w 341"/>
                    <a:gd name="T19" fmla="*/ 119 w 341"/>
                    <a:gd name="T20" fmla="*/ 124 w 341"/>
                    <a:gd name="T21" fmla="*/ 131 w 341"/>
                    <a:gd name="T22" fmla="*/ 136 w 341"/>
                    <a:gd name="T23" fmla="*/ 143 w 341"/>
                    <a:gd name="T24" fmla="*/ 148 w 341"/>
                    <a:gd name="T25" fmla="*/ 155 w 341"/>
                    <a:gd name="T26" fmla="*/ 160 w 341"/>
                    <a:gd name="T27" fmla="*/ 167 w 341"/>
                    <a:gd name="T28" fmla="*/ 172 w 341"/>
                    <a:gd name="T29" fmla="*/ 179 w 341"/>
                    <a:gd name="T30" fmla="*/ 184 w 341"/>
                    <a:gd name="T31" fmla="*/ 191 w 341"/>
                    <a:gd name="T32" fmla="*/ 196 w 341"/>
                    <a:gd name="T33" fmla="*/ 203 w 341"/>
                    <a:gd name="T34" fmla="*/ 208 w 341"/>
                    <a:gd name="T35" fmla="*/ 215 w 341"/>
                    <a:gd name="T36" fmla="*/ 220 w 341"/>
                    <a:gd name="T37" fmla="*/ 227 w 341"/>
                    <a:gd name="T38" fmla="*/ 232 w 341"/>
                    <a:gd name="T39" fmla="*/ 239 w 341"/>
                    <a:gd name="T40" fmla="*/ 244 w 341"/>
                    <a:gd name="T41" fmla="*/ 251 w 341"/>
                    <a:gd name="T42" fmla="*/ 256 w 341"/>
                    <a:gd name="T43" fmla="*/ 263 w 341"/>
                    <a:gd name="T44" fmla="*/ 268 w 341"/>
                    <a:gd name="T45" fmla="*/ 275 w 341"/>
                    <a:gd name="T46" fmla="*/ 280 w 341"/>
                    <a:gd name="T47" fmla="*/ 287 w 341"/>
                    <a:gd name="T48" fmla="*/ 292 w 341"/>
                    <a:gd name="T49" fmla="*/ 299 w 341"/>
                    <a:gd name="T50" fmla="*/ 304 w 341"/>
                    <a:gd name="T51" fmla="*/ 311 w 341"/>
                    <a:gd name="T52" fmla="*/ 316 w 341"/>
                    <a:gd name="T53" fmla="*/ 323 w 341"/>
                    <a:gd name="T54" fmla="*/ 328 w 341"/>
                    <a:gd name="T55" fmla="*/ 335 w 341"/>
                    <a:gd name="T56" fmla="*/ 340 w 341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</a:cxnLst>
                  <a:rect l="0" t="0" r="r" b="b"/>
                  <a:pathLst>
                    <a:path w="341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49" name="Freeform 159"/>
                <p:cNvSpPr>
                  <a:spLocks noEditPoints="1"/>
                </p:cNvSpPr>
                <p:nvPr/>
              </p:nvSpPr>
              <p:spPr bwMode="auto">
                <a:xfrm>
                  <a:off x="5195888" y="5345113"/>
                  <a:ext cx="3390900" cy="0"/>
                </a:xfrm>
                <a:custGeom>
                  <a:avLst/>
                  <a:gdLst>
                    <a:gd name="T0" fmla="*/ 4 w 341"/>
                    <a:gd name="T1" fmla="*/ 11 w 341"/>
                    <a:gd name="T2" fmla="*/ 16 w 341"/>
                    <a:gd name="T3" fmla="*/ 23 w 341"/>
                    <a:gd name="T4" fmla="*/ 28 w 341"/>
                    <a:gd name="T5" fmla="*/ 35 w 341"/>
                    <a:gd name="T6" fmla="*/ 40 w 341"/>
                    <a:gd name="T7" fmla="*/ 47 w 341"/>
                    <a:gd name="T8" fmla="*/ 52 w 341"/>
                    <a:gd name="T9" fmla="*/ 59 w 341"/>
                    <a:gd name="T10" fmla="*/ 64 w 341"/>
                    <a:gd name="T11" fmla="*/ 71 w 341"/>
                    <a:gd name="T12" fmla="*/ 76 w 341"/>
                    <a:gd name="T13" fmla="*/ 83 w 341"/>
                    <a:gd name="T14" fmla="*/ 88 w 341"/>
                    <a:gd name="T15" fmla="*/ 95 w 341"/>
                    <a:gd name="T16" fmla="*/ 100 w 341"/>
                    <a:gd name="T17" fmla="*/ 107 w 341"/>
                    <a:gd name="T18" fmla="*/ 112 w 341"/>
                    <a:gd name="T19" fmla="*/ 119 w 341"/>
                    <a:gd name="T20" fmla="*/ 124 w 341"/>
                    <a:gd name="T21" fmla="*/ 131 w 341"/>
                    <a:gd name="T22" fmla="*/ 136 w 341"/>
                    <a:gd name="T23" fmla="*/ 143 w 341"/>
                    <a:gd name="T24" fmla="*/ 148 w 341"/>
                    <a:gd name="T25" fmla="*/ 155 w 341"/>
                    <a:gd name="T26" fmla="*/ 160 w 341"/>
                    <a:gd name="T27" fmla="*/ 167 w 341"/>
                    <a:gd name="T28" fmla="*/ 172 w 341"/>
                    <a:gd name="T29" fmla="*/ 179 w 341"/>
                    <a:gd name="T30" fmla="*/ 184 w 341"/>
                    <a:gd name="T31" fmla="*/ 191 w 341"/>
                    <a:gd name="T32" fmla="*/ 196 w 341"/>
                    <a:gd name="T33" fmla="*/ 203 w 341"/>
                    <a:gd name="T34" fmla="*/ 208 w 341"/>
                    <a:gd name="T35" fmla="*/ 215 w 341"/>
                    <a:gd name="T36" fmla="*/ 220 w 341"/>
                    <a:gd name="T37" fmla="*/ 227 w 341"/>
                    <a:gd name="T38" fmla="*/ 232 w 341"/>
                    <a:gd name="T39" fmla="*/ 239 w 341"/>
                    <a:gd name="T40" fmla="*/ 244 w 341"/>
                    <a:gd name="T41" fmla="*/ 251 w 341"/>
                    <a:gd name="T42" fmla="*/ 256 w 341"/>
                    <a:gd name="T43" fmla="*/ 263 w 341"/>
                    <a:gd name="T44" fmla="*/ 268 w 341"/>
                    <a:gd name="T45" fmla="*/ 275 w 341"/>
                    <a:gd name="T46" fmla="*/ 280 w 341"/>
                    <a:gd name="T47" fmla="*/ 287 w 341"/>
                    <a:gd name="T48" fmla="*/ 292 w 341"/>
                    <a:gd name="T49" fmla="*/ 299 w 341"/>
                    <a:gd name="T50" fmla="*/ 304 w 341"/>
                    <a:gd name="T51" fmla="*/ 311 w 341"/>
                    <a:gd name="T52" fmla="*/ 316 w 341"/>
                    <a:gd name="T53" fmla="*/ 323 w 341"/>
                    <a:gd name="T54" fmla="*/ 328 w 341"/>
                    <a:gd name="T55" fmla="*/ 335 w 341"/>
                    <a:gd name="T56" fmla="*/ 340 w 341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</a:cxnLst>
                  <a:rect l="0" t="0" r="r" b="b"/>
                  <a:pathLst>
                    <a:path w="341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</p:grpSp>
        <p:grpSp>
          <p:nvGrpSpPr>
            <p:cNvPr id="174" name="Group 173"/>
            <p:cNvGrpSpPr/>
            <p:nvPr/>
          </p:nvGrpSpPr>
          <p:grpSpPr>
            <a:xfrm>
              <a:off x="7121927" y="838200"/>
              <a:ext cx="1793473" cy="1155490"/>
              <a:chOff x="5562600" y="868148"/>
              <a:chExt cx="1793473" cy="1155490"/>
            </a:xfrm>
          </p:grpSpPr>
          <p:sp>
            <p:nvSpPr>
              <p:cNvPr id="162" name="Rectangle 659"/>
              <p:cNvSpPr>
                <a:spLocks noChangeArrowheads="1"/>
              </p:cNvSpPr>
              <p:nvPr/>
            </p:nvSpPr>
            <p:spPr bwMode="auto">
              <a:xfrm>
                <a:off x="5562600" y="868148"/>
                <a:ext cx="1692464" cy="1152398"/>
              </a:xfrm>
              <a:prstGeom prst="rect">
                <a:avLst/>
              </a:prstGeom>
              <a:noFill/>
              <a:ln w="4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50"/>
              </a:p>
            </p:txBody>
          </p:sp>
          <p:sp>
            <p:nvSpPr>
              <p:cNvPr id="163" name="Freeform 660"/>
              <p:cNvSpPr>
                <a:spLocks/>
              </p:cNvSpPr>
              <p:nvPr/>
            </p:nvSpPr>
            <p:spPr bwMode="auto">
              <a:xfrm>
                <a:off x="5683768" y="1012059"/>
                <a:ext cx="81316" cy="56240"/>
              </a:xfrm>
              <a:custGeom>
                <a:avLst/>
                <a:gdLst>
                  <a:gd name="T0" fmla="*/ 18 w 36"/>
                  <a:gd name="T1" fmla="*/ 0 h 31"/>
                  <a:gd name="T2" fmla="*/ 36 w 36"/>
                  <a:gd name="T3" fmla="*/ 31 h 31"/>
                  <a:gd name="T4" fmla="*/ 0 w 36"/>
                  <a:gd name="T5" fmla="*/ 31 h 31"/>
                  <a:gd name="T6" fmla="*/ 18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18" y="0"/>
                    </a:moveTo>
                    <a:lnTo>
                      <a:pt x="36" y="31"/>
                    </a:lnTo>
                    <a:lnTo>
                      <a:pt x="0" y="31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50"/>
              </a:p>
            </p:txBody>
          </p:sp>
          <p:sp>
            <p:nvSpPr>
              <p:cNvPr id="164" name="Freeform 663"/>
              <p:cNvSpPr>
                <a:spLocks/>
              </p:cNvSpPr>
              <p:nvPr/>
            </p:nvSpPr>
            <p:spPr bwMode="auto">
              <a:xfrm>
                <a:off x="5683768" y="1234003"/>
                <a:ext cx="81316" cy="56240"/>
              </a:xfrm>
              <a:custGeom>
                <a:avLst/>
                <a:gdLst>
                  <a:gd name="T0" fmla="*/ 4 w 8"/>
                  <a:gd name="T1" fmla="*/ 7 h 7"/>
                  <a:gd name="T2" fmla="*/ 8 w 8"/>
                  <a:gd name="T3" fmla="*/ 0 h 7"/>
                  <a:gd name="T4" fmla="*/ 0 w 8"/>
                  <a:gd name="T5" fmla="*/ 0 h 7"/>
                  <a:gd name="T6" fmla="*/ 4 w 8"/>
                  <a:gd name="T7" fmla="*/ 7 h 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8" h="7">
                    <a:moveTo>
                      <a:pt x="4" y="7"/>
                    </a:moveTo>
                    <a:lnTo>
                      <a:pt x="8" y="0"/>
                    </a:lnTo>
                    <a:lnTo>
                      <a:pt x="0" y="0"/>
                    </a:lnTo>
                    <a:lnTo>
                      <a:pt x="4" y="7"/>
                    </a:lnTo>
                  </a:path>
                </a:pathLst>
              </a:custGeom>
              <a:noFill/>
              <a:ln w="4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50"/>
              </a:p>
            </p:txBody>
          </p:sp>
          <p:sp>
            <p:nvSpPr>
              <p:cNvPr id="165" name="Rectangle 664"/>
              <p:cNvSpPr>
                <a:spLocks noChangeArrowheads="1"/>
              </p:cNvSpPr>
              <p:nvPr/>
            </p:nvSpPr>
            <p:spPr bwMode="auto">
              <a:xfrm>
                <a:off x="5844142" y="947975"/>
                <a:ext cx="299762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5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VDL</a:t>
                </a:r>
                <a:endParaRPr kumimoji="0" lang="en-US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6" name="Rectangle 667"/>
              <p:cNvSpPr>
                <a:spLocks noChangeArrowheads="1"/>
              </p:cNvSpPr>
              <p:nvPr/>
            </p:nvSpPr>
            <p:spPr bwMode="auto">
              <a:xfrm>
                <a:off x="5844142" y="1155405"/>
                <a:ext cx="360676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5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KHDL</a:t>
                </a:r>
                <a:endParaRPr kumimoji="0" lang="en-US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7" name="Rectangle 76"/>
              <p:cNvSpPr>
                <a:spLocks noChangeArrowheads="1"/>
              </p:cNvSpPr>
              <p:nvPr/>
            </p:nvSpPr>
            <p:spPr bwMode="auto">
              <a:xfrm>
                <a:off x="5657242" y="1913248"/>
                <a:ext cx="121174" cy="45719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050"/>
              </a:p>
            </p:txBody>
          </p:sp>
          <p:sp>
            <p:nvSpPr>
              <p:cNvPr id="168" name="Rectangle 74"/>
              <p:cNvSpPr>
                <a:spLocks noChangeArrowheads="1"/>
              </p:cNvSpPr>
              <p:nvPr/>
            </p:nvSpPr>
            <p:spPr bwMode="auto">
              <a:xfrm>
                <a:off x="5658520" y="1706997"/>
                <a:ext cx="118134" cy="4571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400"/>
              </a:p>
            </p:txBody>
          </p:sp>
          <p:sp>
            <p:nvSpPr>
              <p:cNvPr id="169" name="Rectangle 72"/>
              <p:cNvSpPr>
                <a:spLocks noChangeArrowheads="1"/>
              </p:cNvSpPr>
              <p:nvPr/>
            </p:nvSpPr>
            <p:spPr bwMode="auto">
              <a:xfrm>
                <a:off x="5658520" y="1531233"/>
                <a:ext cx="119896" cy="45719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400"/>
              </a:p>
            </p:txBody>
          </p:sp>
          <p:sp>
            <p:nvSpPr>
              <p:cNvPr id="170" name="Rectangle 169"/>
              <p:cNvSpPr/>
              <p:nvPr/>
            </p:nvSpPr>
            <p:spPr>
              <a:xfrm>
                <a:off x="5783721" y="1365640"/>
                <a:ext cx="132279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Small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1" name="Rectangle 170"/>
              <p:cNvSpPr/>
              <p:nvPr/>
            </p:nvSpPr>
            <p:spPr>
              <a:xfrm>
                <a:off x="5792825" y="1551731"/>
                <a:ext cx="156324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Moderate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2" name="Rectangle 171"/>
              <p:cNvSpPr/>
              <p:nvPr/>
            </p:nvSpPr>
            <p:spPr>
              <a:xfrm>
                <a:off x="5798263" y="1762028"/>
                <a:ext cx="132921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Large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76" name="TextBox 175"/>
          <p:cNvSpPr txBox="1"/>
          <p:nvPr/>
        </p:nvSpPr>
        <p:spPr>
          <a:xfrm>
            <a:off x="0" y="6525399"/>
            <a:ext cx="9144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itchFamily="34" charset="0"/>
                <a:cs typeface="Arial" pitchFamily="34" charset="0"/>
              </a:rPr>
              <a:t>Appendix Figure 1</a:t>
            </a:r>
            <a:endParaRPr lang="el-GR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76232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402</TotalTime>
  <Words>131</Words>
  <Application>Microsoft Office PowerPoint</Application>
  <PresentationFormat>On-screen Show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gie</dc:creator>
  <cp:lastModifiedBy>Argie</cp:lastModifiedBy>
  <cp:revision>576</cp:revision>
  <dcterms:created xsi:type="dcterms:W3CDTF">2006-08-16T00:00:00Z</dcterms:created>
  <dcterms:modified xsi:type="dcterms:W3CDTF">2014-06-07T23:02:36Z</dcterms:modified>
</cp:coreProperties>
</file>